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1D1C10-4C23-4889-BD08-A1E028F6B93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9AF23F-83B0-40E6-946C-B5B76F604F4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99633C-5CF9-4DD7-B671-84D4075C2CA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123F8B-A02B-4E50-8AAA-AA286BF9ED7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99503B-DB1F-45EC-957A-49C9D6E967B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4AE23B-BB64-4E47-9A1F-E24C54AF884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52A0F9-EBE2-4535-8BBB-BF1631C4D1F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E67D26-92AB-48DA-B6B3-3AACA64F4E6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51BB8D-4F48-4EFF-8151-9DF3E143229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2D1B2C-AA1B-458F-8A16-6BE78498EDD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382F83-C1A8-4E24-94FF-610135623CF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08E2A0-F331-4A45-AE1C-404B0814E8D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CA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76D7352-D9BB-4574-A12F-C8AA6F2FEDDC}" type="slidenum">
              <a:rPr b="0" lang="en-CA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176"/>
          <p:cNvGrpSpPr/>
          <p:nvPr/>
        </p:nvGrpSpPr>
        <p:grpSpPr>
          <a:xfrm>
            <a:off x="1241280" y="193680"/>
            <a:ext cx="5473800" cy="8659800"/>
            <a:chOff x="1241280" y="193680"/>
            <a:chExt cx="5473800" cy="8659800"/>
          </a:xfrm>
        </p:grpSpPr>
        <p:grpSp>
          <p:nvGrpSpPr>
            <p:cNvPr id="42" name="Group 6"/>
            <p:cNvGrpSpPr/>
            <p:nvPr/>
          </p:nvGrpSpPr>
          <p:grpSpPr>
            <a:xfrm>
              <a:off x="1241280" y="193680"/>
              <a:ext cx="4044960" cy="8659800"/>
              <a:chOff x="1241280" y="193680"/>
              <a:chExt cx="4044960" cy="8659800"/>
            </a:xfrm>
          </p:grpSpPr>
          <p:sp>
            <p:nvSpPr>
              <p:cNvPr id="43" name="AutoShape 5"/>
              <p:cNvSpPr/>
              <p:nvPr/>
            </p:nvSpPr>
            <p:spPr>
              <a:xfrm>
                <a:off x="1241280" y="193680"/>
                <a:ext cx="4044960" cy="8659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4" name="Rectangle 7"/>
              <p:cNvSpPr/>
              <p:nvPr/>
            </p:nvSpPr>
            <p:spPr>
              <a:xfrm>
                <a:off x="4210920" y="306360"/>
                <a:ext cx="480960" cy="138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 </a:t>
                </a: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Salmon </a:t>
                </a: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ＭＳ Ｐゴシック"/>
                  </a:rPr>
                  <a:t>μ</a:t>
                </a:r>
                <a:r>
                  <a:rPr b="1" lang="en-US" sz="800" spc="-1" strike="noStrike" baseline="-25000">
                    <a:solidFill>
                      <a:srgbClr val="000000"/>
                    </a:solidFill>
                    <a:latin typeface="Times New Roman"/>
                    <a:ea typeface="Arial"/>
                  </a:rPr>
                  <a:t>B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5" name="Freeform 8"/>
              <p:cNvSpPr/>
              <p:nvPr/>
            </p:nvSpPr>
            <p:spPr>
              <a:xfrm>
                <a:off x="4084560" y="374760"/>
                <a:ext cx="119160" cy="93600"/>
              </a:xfrm>
              <a:custGeom>
                <a:avLst/>
                <a:gdLst>
                  <a:gd name="textAreaLeft" fmla="*/ 0 w 119160"/>
                  <a:gd name="textAreaRight" fmla="*/ 119520 w 119160"/>
                  <a:gd name="textAreaTop" fmla="*/ 0 h 93600"/>
                  <a:gd name="textAreaBottom" fmla="*/ 93960 h 93600"/>
                </a:gdLst>
                <a:ahLst/>
                <a:rect l="textAreaLeft" t="textAreaTop" r="textAreaRight" b="textAreaBottom"/>
                <a:pathLst>
                  <a:path w="75" h="59">
                    <a:moveTo>
                      <a:pt x="0" y="59"/>
                    </a:moveTo>
                    <a:lnTo>
                      <a:pt x="0" y="0"/>
                    </a:lnTo>
                    <a:lnTo>
                      <a:pt x="75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6" name="Rectangle 9"/>
              <p:cNvSpPr/>
              <p:nvPr/>
            </p:nvSpPr>
            <p:spPr>
              <a:xfrm>
                <a:off x="4200480" y="501840"/>
                <a:ext cx="484200" cy="138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 </a:t>
                </a: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Salmon </a:t>
                </a: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ＭＳ Ｐゴシック"/>
                  </a:rPr>
                  <a:t>μ</a:t>
                </a:r>
                <a:r>
                  <a:rPr b="1" lang="en-US" sz="800" spc="-1" strike="noStrike" baseline="-25000">
                    <a:solidFill>
                      <a:srgbClr val="000000"/>
                    </a:solidFill>
                    <a:latin typeface="Times New Roman"/>
                    <a:ea typeface="Arial"/>
                  </a:rPr>
                  <a:t>A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7" name="Freeform 10"/>
              <p:cNvSpPr/>
              <p:nvPr/>
            </p:nvSpPr>
            <p:spPr>
              <a:xfrm>
                <a:off x="4084560" y="476280"/>
                <a:ext cx="109440" cy="93600"/>
              </a:xfrm>
              <a:custGeom>
                <a:avLst/>
                <a:gdLst>
                  <a:gd name="textAreaLeft" fmla="*/ 0 w 109440"/>
                  <a:gd name="textAreaRight" fmla="*/ 109800 w 109440"/>
                  <a:gd name="textAreaTop" fmla="*/ 0 h 93600"/>
                  <a:gd name="textAreaBottom" fmla="*/ 93960 h 93600"/>
                </a:gdLst>
                <a:ahLst/>
                <a:rect l="textAreaLeft" t="textAreaTop" r="textAreaRight" b="textAreaBottom"/>
                <a:pathLst>
                  <a:path w="69" h="59">
                    <a:moveTo>
                      <a:pt x="0" y="0"/>
                    </a:moveTo>
                    <a:lnTo>
                      <a:pt x="0" y="59"/>
                    </a:lnTo>
                    <a:lnTo>
                      <a:pt x="69" y="59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8" name="Freeform 11"/>
              <p:cNvSpPr/>
              <p:nvPr/>
            </p:nvSpPr>
            <p:spPr>
              <a:xfrm>
                <a:off x="3817800" y="473040"/>
                <a:ext cx="266760" cy="141480"/>
              </a:xfrm>
              <a:custGeom>
                <a:avLst/>
                <a:gdLst>
                  <a:gd name="textAreaLeft" fmla="*/ 0 w 266760"/>
                  <a:gd name="textAreaRight" fmla="*/ 267120 w 266760"/>
                  <a:gd name="textAreaTop" fmla="*/ 0 h 141480"/>
                  <a:gd name="textAreaBottom" fmla="*/ 141840 h 141480"/>
                </a:gdLst>
                <a:ahLst/>
                <a:rect l="textAreaLeft" t="textAreaTop" r="textAreaRight" b="textAreaBottom"/>
                <a:pathLst>
                  <a:path w="168" h="89">
                    <a:moveTo>
                      <a:pt x="0" y="89"/>
                    </a:moveTo>
                    <a:lnTo>
                      <a:pt x="0" y="0"/>
                    </a:lnTo>
                    <a:lnTo>
                      <a:pt x="168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9" name="Rectangle 12"/>
              <p:cNvSpPr/>
              <p:nvPr/>
            </p:nvSpPr>
            <p:spPr>
              <a:xfrm>
                <a:off x="4187160" y="696960"/>
                <a:ext cx="3664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 </a:t>
                </a: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Trout </a:t>
                </a:r>
                <a:r>
                  <a:rPr b="1" lang="el-GR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μ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0" name="Freeform 13"/>
              <p:cNvSpPr/>
              <p:nvPr/>
            </p:nvSpPr>
            <p:spPr>
              <a:xfrm>
                <a:off x="3817800" y="622440"/>
                <a:ext cx="365400" cy="142920"/>
              </a:xfrm>
              <a:custGeom>
                <a:avLst/>
                <a:gdLst>
                  <a:gd name="textAreaLeft" fmla="*/ 0 w 365400"/>
                  <a:gd name="textAreaRight" fmla="*/ 365760 w 365400"/>
                  <a:gd name="textAreaTop" fmla="*/ 0 h 142920"/>
                  <a:gd name="textAreaBottom" fmla="*/ 143280 h 142920"/>
                </a:gdLst>
                <a:ahLst/>
                <a:rect l="textAreaLeft" t="textAreaTop" r="textAreaRight" b="textAreaBottom"/>
                <a:pathLst>
                  <a:path w="230" h="90">
                    <a:moveTo>
                      <a:pt x="0" y="0"/>
                    </a:moveTo>
                    <a:lnTo>
                      <a:pt x="0" y="90"/>
                    </a:lnTo>
                    <a:lnTo>
                      <a:pt x="230" y="9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1" name="Freeform 14"/>
              <p:cNvSpPr/>
              <p:nvPr/>
            </p:nvSpPr>
            <p:spPr>
              <a:xfrm>
                <a:off x="2424240" y="619200"/>
                <a:ext cx="1393560" cy="312840"/>
              </a:xfrm>
              <a:custGeom>
                <a:avLst/>
                <a:gdLst>
                  <a:gd name="textAreaLeft" fmla="*/ 0 w 1393560"/>
                  <a:gd name="textAreaRight" fmla="*/ 1393920 w 1393560"/>
                  <a:gd name="textAreaTop" fmla="*/ 0 h 312840"/>
                  <a:gd name="textAreaBottom" fmla="*/ 312840 h 312840"/>
                </a:gdLst>
                <a:ahLst/>
                <a:rect l="textAreaLeft" t="textAreaTop" r="textAreaRight" b="textAreaBottom"/>
                <a:pathLst>
                  <a:path w="878" h="197">
                    <a:moveTo>
                      <a:pt x="0" y="197"/>
                    </a:moveTo>
                    <a:lnTo>
                      <a:pt x="0" y="0"/>
                    </a:lnTo>
                    <a:lnTo>
                      <a:pt x="878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2" name="Rectangle 15"/>
              <p:cNvSpPr/>
              <p:nvPr/>
            </p:nvSpPr>
            <p:spPr>
              <a:xfrm>
                <a:off x="4251600" y="893880"/>
                <a:ext cx="4276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 </a:t>
                </a: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Catfish </a:t>
                </a:r>
                <a:r>
                  <a:rPr b="1" lang="el-GR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μ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3" name="Freeform 16"/>
              <p:cNvSpPr/>
              <p:nvPr/>
            </p:nvSpPr>
            <p:spPr>
              <a:xfrm>
                <a:off x="2424240" y="960480"/>
                <a:ext cx="1822320" cy="142920"/>
              </a:xfrm>
              <a:custGeom>
                <a:avLst/>
                <a:gdLst>
                  <a:gd name="textAreaLeft" fmla="*/ 0 w 1822320"/>
                  <a:gd name="textAreaRight" fmla="*/ 1822680 w 1822320"/>
                  <a:gd name="textAreaTop" fmla="*/ 0 h 142920"/>
                  <a:gd name="textAreaBottom" fmla="*/ 143280 h 142920"/>
                </a:gdLst>
                <a:ahLst/>
                <a:rect l="textAreaLeft" t="textAreaTop" r="textAreaRight" b="textAreaBottom"/>
                <a:pathLst>
                  <a:path w="1148" h="90">
                    <a:moveTo>
                      <a:pt x="0" y="90"/>
                    </a:moveTo>
                    <a:lnTo>
                      <a:pt x="0" y="0"/>
                    </a:lnTo>
                    <a:lnTo>
                      <a:pt x="1148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4" name="Rectangle 17"/>
              <p:cNvSpPr/>
              <p:nvPr/>
            </p:nvSpPr>
            <p:spPr>
              <a:xfrm>
                <a:off x="4375080" y="1089000"/>
                <a:ext cx="5371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 </a:t>
                </a: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Zebrafish </a:t>
                </a:r>
                <a:r>
                  <a:rPr b="1" lang="el-GR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μ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5" name="Freeform 18"/>
              <p:cNvSpPr/>
              <p:nvPr/>
            </p:nvSpPr>
            <p:spPr>
              <a:xfrm>
                <a:off x="2840040" y="1155960"/>
                <a:ext cx="1530360" cy="93600"/>
              </a:xfrm>
              <a:custGeom>
                <a:avLst/>
                <a:gdLst>
                  <a:gd name="textAreaLeft" fmla="*/ 0 w 1530360"/>
                  <a:gd name="textAreaRight" fmla="*/ 1530720 w 1530360"/>
                  <a:gd name="textAreaTop" fmla="*/ 0 h 93600"/>
                  <a:gd name="textAreaBottom" fmla="*/ 93960 h 93600"/>
                </a:gdLst>
                <a:ahLst/>
                <a:rect l="textAreaLeft" t="textAreaTop" r="textAreaRight" b="textAreaBottom"/>
                <a:pathLst>
                  <a:path w="964" h="59">
                    <a:moveTo>
                      <a:pt x="0" y="59"/>
                    </a:moveTo>
                    <a:lnTo>
                      <a:pt x="0" y="0"/>
                    </a:lnTo>
                    <a:lnTo>
                      <a:pt x="964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6" name="Rectangle 19"/>
              <p:cNvSpPr/>
              <p:nvPr/>
            </p:nvSpPr>
            <p:spPr>
              <a:xfrm>
                <a:off x="4301640" y="1284480"/>
                <a:ext cx="3376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 </a:t>
                </a: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Carp </a:t>
                </a:r>
                <a:r>
                  <a:rPr b="1" lang="el-GR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μ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7" name="Freeform 20"/>
              <p:cNvSpPr/>
              <p:nvPr/>
            </p:nvSpPr>
            <p:spPr>
              <a:xfrm>
                <a:off x="2840040" y="1257480"/>
                <a:ext cx="1457280" cy="93600"/>
              </a:xfrm>
              <a:custGeom>
                <a:avLst/>
                <a:gdLst>
                  <a:gd name="textAreaLeft" fmla="*/ 0 w 1457280"/>
                  <a:gd name="textAreaRight" fmla="*/ 1457640 w 1457280"/>
                  <a:gd name="textAreaTop" fmla="*/ 0 h 93600"/>
                  <a:gd name="textAreaBottom" fmla="*/ 93960 h 93600"/>
                </a:gdLst>
                <a:ahLst/>
                <a:rect l="textAreaLeft" t="textAreaTop" r="textAreaRight" b="textAreaBottom"/>
                <a:pathLst>
                  <a:path w="918" h="59">
                    <a:moveTo>
                      <a:pt x="0" y="0"/>
                    </a:moveTo>
                    <a:lnTo>
                      <a:pt x="0" y="59"/>
                    </a:lnTo>
                    <a:lnTo>
                      <a:pt x="918" y="59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8" name="Freeform 21"/>
              <p:cNvSpPr/>
              <p:nvPr/>
            </p:nvSpPr>
            <p:spPr>
              <a:xfrm>
                <a:off x="2424240" y="1111320"/>
                <a:ext cx="415800" cy="142920"/>
              </a:xfrm>
              <a:custGeom>
                <a:avLst/>
                <a:gdLst>
                  <a:gd name="textAreaLeft" fmla="*/ 0 w 415800"/>
                  <a:gd name="textAreaRight" fmla="*/ 416160 w 415800"/>
                  <a:gd name="textAreaTop" fmla="*/ 0 h 142920"/>
                  <a:gd name="textAreaBottom" fmla="*/ 143280 h 142920"/>
                </a:gdLst>
                <a:ahLst/>
                <a:rect l="textAreaLeft" t="textAreaTop" r="textAreaRight" b="textAreaBottom"/>
                <a:pathLst>
                  <a:path w="262" h="90">
                    <a:moveTo>
                      <a:pt x="0" y="0"/>
                    </a:moveTo>
                    <a:lnTo>
                      <a:pt x="0" y="90"/>
                    </a:lnTo>
                    <a:lnTo>
                      <a:pt x="262" y="9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9" name="Line 22"/>
              <p:cNvSpPr/>
              <p:nvPr/>
            </p:nvSpPr>
            <p:spPr>
              <a:xfrm>
                <a:off x="2424240" y="939960"/>
                <a:ext cx="1440" cy="31428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0" name="Freeform 23"/>
              <p:cNvSpPr/>
              <p:nvPr/>
            </p:nvSpPr>
            <p:spPr>
              <a:xfrm>
                <a:off x="2149560" y="936720"/>
                <a:ext cx="274680" cy="301680"/>
              </a:xfrm>
              <a:custGeom>
                <a:avLst/>
                <a:gdLst>
                  <a:gd name="textAreaLeft" fmla="*/ 0 w 274680"/>
                  <a:gd name="textAreaRight" fmla="*/ 275040 w 274680"/>
                  <a:gd name="textAreaTop" fmla="*/ 0 h 301680"/>
                  <a:gd name="textAreaBottom" fmla="*/ 302040 h 301680"/>
                </a:gdLst>
                <a:ahLst/>
                <a:rect l="textAreaLeft" t="textAreaTop" r="textAreaRight" b="textAreaBottom"/>
                <a:pathLst>
                  <a:path w="173" h="190">
                    <a:moveTo>
                      <a:pt x="0" y="190"/>
                    </a:moveTo>
                    <a:lnTo>
                      <a:pt x="0" y="0"/>
                    </a:lnTo>
                    <a:lnTo>
                      <a:pt x="173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1" name="Rectangle 24"/>
              <p:cNvSpPr/>
              <p:nvPr/>
            </p:nvSpPr>
            <p:spPr>
              <a:xfrm>
                <a:off x="4169160" y="1479600"/>
                <a:ext cx="4975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 </a:t>
                </a: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Ladyfish </a:t>
                </a:r>
                <a:r>
                  <a:rPr b="1" lang="el-GR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μ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2" name="Freeform 25"/>
              <p:cNvSpPr/>
              <p:nvPr/>
            </p:nvSpPr>
            <p:spPr>
              <a:xfrm>
                <a:off x="2149560" y="1246320"/>
                <a:ext cx="2016000" cy="299880"/>
              </a:xfrm>
              <a:custGeom>
                <a:avLst/>
                <a:gdLst>
                  <a:gd name="textAreaLeft" fmla="*/ 0 w 2016000"/>
                  <a:gd name="textAreaRight" fmla="*/ 2016000 w 2016000"/>
                  <a:gd name="textAreaTop" fmla="*/ 0 h 299880"/>
                  <a:gd name="textAreaBottom" fmla="*/ 300240 h 299880"/>
                </a:gdLst>
                <a:ahLst/>
                <a:rect l="textAreaLeft" t="textAreaTop" r="textAreaRight" b="textAreaBottom"/>
                <a:pathLst>
                  <a:path w="1270" h="189">
                    <a:moveTo>
                      <a:pt x="0" y="0"/>
                    </a:moveTo>
                    <a:lnTo>
                      <a:pt x="0" y="189"/>
                    </a:lnTo>
                    <a:lnTo>
                      <a:pt x="1270" y="189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3" name="Freeform 26"/>
              <p:cNvSpPr/>
              <p:nvPr/>
            </p:nvSpPr>
            <p:spPr>
              <a:xfrm>
                <a:off x="1862280" y="1241640"/>
                <a:ext cx="287280" cy="318960"/>
              </a:xfrm>
              <a:custGeom>
                <a:avLst/>
                <a:gdLst>
                  <a:gd name="textAreaLeft" fmla="*/ 0 w 287280"/>
                  <a:gd name="textAreaRight" fmla="*/ 287640 w 287280"/>
                  <a:gd name="textAreaTop" fmla="*/ 0 h 318960"/>
                  <a:gd name="textAreaBottom" fmla="*/ 319320 h 318960"/>
                </a:gdLst>
                <a:ahLst/>
                <a:rect l="textAreaLeft" t="textAreaTop" r="textAreaRight" b="textAreaBottom"/>
                <a:pathLst>
                  <a:path w="181" h="201">
                    <a:moveTo>
                      <a:pt x="0" y="201"/>
                    </a:moveTo>
                    <a:lnTo>
                      <a:pt x="0" y="0"/>
                    </a:lnTo>
                    <a:lnTo>
                      <a:pt x="181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4" name="Rectangle 27"/>
              <p:cNvSpPr/>
              <p:nvPr/>
            </p:nvSpPr>
            <p:spPr>
              <a:xfrm>
                <a:off x="4044960" y="1674720"/>
                <a:ext cx="5083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 </a:t>
                </a: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Sturgeon </a:t>
                </a:r>
                <a:r>
                  <a:rPr b="1" lang="el-GR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μ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5" name="Freeform 28"/>
              <p:cNvSpPr/>
              <p:nvPr/>
            </p:nvSpPr>
            <p:spPr>
              <a:xfrm>
                <a:off x="2135160" y="1741680"/>
                <a:ext cx="1906560" cy="142920"/>
              </a:xfrm>
              <a:custGeom>
                <a:avLst/>
                <a:gdLst>
                  <a:gd name="textAreaLeft" fmla="*/ 0 w 1906560"/>
                  <a:gd name="textAreaRight" fmla="*/ 1906920 w 1906560"/>
                  <a:gd name="textAreaTop" fmla="*/ 0 h 142920"/>
                  <a:gd name="textAreaBottom" fmla="*/ 143280 h 142920"/>
                </a:gdLst>
                <a:ahLst/>
                <a:rect l="textAreaLeft" t="textAreaTop" r="textAreaRight" b="textAreaBottom"/>
                <a:pathLst>
                  <a:path w="1201" h="90">
                    <a:moveTo>
                      <a:pt x="0" y="90"/>
                    </a:moveTo>
                    <a:lnTo>
                      <a:pt x="0" y="0"/>
                    </a:lnTo>
                    <a:lnTo>
                      <a:pt x="1201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6" name="Rectangle 29"/>
              <p:cNvSpPr/>
              <p:nvPr/>
            </p:nvSpPr>
            <p:spPr>
              <a:xfrm>
                <a:off x="3979080" y="1870200"/>
                <a:ext cx="2872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 </a:t>
                </a: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Gar </a:t>
                </a:r>
                <a:r>
                  <a:rPr b="1" lang="el-GR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μ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7" name="Freeform 30"/>
              <p:cNvSpPr/>
              <p:nvPr/>
            </p:nvSpPr>
            <p:spPr>
              <a:xfrm>
                <a:off x="2525760" y="1936800"/>
                <a:ext cx="1450800" cy="93600"/>
              </a:xfrm>
              <a:custGeom>
                <a:avLst/>
                <a:gdLst>
                  <a:gd name="textAreaLeft" fmla="*/ 0 w 1450800"/>
                  <a:gd name="textAreaRight" fmla="*/ 1450800 w 1450800"/>
                  <a:gd name="textAreaTop" fmla="*/ 0 h 93600"/>
                  <a:gd name="textAreaBottom" fmla="*/ 93960 h 93600"/>
                </a:gdLst>
                <a:ahLst/>
                <a:rect l="textAreaLeft" t="textAreaTop" r="textAreaRight" b="textAreaBottom"/>
                <a:pathLst>
                  <a:path w="914" h="59">
                    <a:moveTo>
                      <a:pt x="0" y="59"/>
                    </a:moveTo>
                    <a:lnTo>
                      <a:pt x="0" y="0"/>
                    </a:lnTo>
                    <a:lnTo>
                      <a:pt x="914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8" name="Rectangle 31"/>
              <p:cNvSpPr/>
              <p:nvPr/>
            </p:nvSpPr>
            <p:spPr>
              <a:xfrm>
                <a:off x="4064400" y="2065320"/>
                <a:ext cx="4230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 </a:t>
                </a: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Bowfin </a:t>
                </a:r>
                <a:r>
                  <a:rPr b="1" lang="el-GR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μ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9" name="Freeform 32"/>
              <p:cNvSpPr/>
              <p:nvPr/>
            </p:nvSpPr>
            <p:spPr>
              <a:xfrm>
                <a:off x="2525760" y="2040120"/>
                <a:ext cx="1533600" cy="91800"/>
              </a:xfrm>
              <a:custGeom>
                <a:avLst/>
                <a:gdLst>
                  <a:gd name="textAreaLeft" fmla="*/ 0 w 1533600"/>
                  <a:gd name="textAreaRight" fmla="*/ 1533960 w 1533600"/>
                  <a:gd name="textAreaTop" fmla="*/ 0 h 91800"/>
                  <a:gd name="textAreaBottom" fmla="*/ 92160 h 91800"/>
                </a:gdLst>
                <a:ahLst/>
                <a:rect l="textAreaLeft" t="textAreaTop" r="textAreaRight" b="textAreaBottom"/>
                <a:pathLst>
                  <a:path w="966" h="58">
                    <a:moveTo>
                      <a:pt x="0" y="0"/>
                    </a:moveTo>
                    <a:lnTo>
                      <a:pt x="0" y="58"/>
                    </a:lnTo>
                    <a:lnTo>
                      <a:pt x="966" y="58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0" name="Freeform 33"/>
              <p:cNvSpPr/>
              <p:nvPr/>
            </p:nvSpPr>
            <p:spPr>
              <a:xfrm>
                <a:off x="2135160" y="1892520"/>
                <a:ext cx="390600" cy="142560"/>
              </a:xfrm>
              <a:custGeom>
                <a:avLst/>
                <a:gdLst>
                  <a:gd name="textAreaLeft" fmla="*/ 0 w 390600"/>
                  <a:gd name="textAreaRight" fmla="*/ 390960 w 390600"/>
                  <a:gd name="textAreaTop" fmla="*/ 0 h 142560"/>
                  <a:gd name="textAreaBottom" fmla="*/ 142920 h 142560"/>
                </a:gdLst>
                <a:ahLst/>
                <a:rect l="textAreaLeft" t="textAreaTop" r="textAreaRight" b="textAreaBottom"/>
                <a:pathLst>
                  <a:path w="246" h="90">
                    <a:moveTo>
                      <a:pt x="0" y="0"/>
                    </a:moveTo>
                    <a:lnTo>
                      <a:pt x="0" y="90"/>
                    </a:lnTo>
                    <a:lnTo>
                      <a:pt x="246" y="9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1" name="Freeform 34"/>
              <p:cNvSpPr/>
              <p:nvPr/>
            </p:nvSpPr>
            <p:spPr>
              <a:xfrm>
                <a:off x="1862280" y="1568520"/>
                <a:ext cx="272880" cy="320760"/>
              </a:xfrm>
              <a:custGeom>
                <a:avLst/>
                <a:gdLst>
                  <a:gd name="textAreaLeft" fmla="*/ 0 w 272880"/>
                  <a:gd name="textAreaRight" fmla="*/ 273240 w 272880"/>
                  <a:gd name="textAreaTop" fmla="*/ 0 h 320760"/>
                  <a:gd name="textAreaBottom" fmla="*/ 321120 h 320760"/>
                </a:gdLst>
                <a:ahLst/>
                <a:rect l="textAreaLeft" t="textAreaTop" r="textAreaRight" b="textAreaBottom"/>
                <a:pathLst>
                  <a:path w="172" h="202">
                    <a:moveTo>
                      <a:pt x="0" y="0"/>
                    </a:moveTo>
                    <a:lnTo>
                      <a:pt x="0" y="202"/>
                    </a:lnTo>
                    <a:lnTo>
                      <a:pt x="172" y="202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2" name="Freeform 35"/>
              <p:cNvSpPr/>
              <p:nvPr/>
            </p:nvSpPr>
            <p:spPr>
              <a:xfrm>
                <a:off x="1525680" y="1565280"/>
                <a:ext cx="336600" cy="1416240"/>
              </a:xfrm>
              <a:custGeom>
                <a:avLst/>
                <a:gdLst>
                  <a:gd name="textAreaLeft" fmla="*/ 0 w 336600"/>
                  <a:gd name="textAreaRight" fmla="*/ 336960 w 336600"/>
                  <a:gd name="textAreaTop" fmla="*/ 0 h 1416240"/>
                  <a:gd name="textAreaBottom" fmla="*/ 1416240 h 1416240"/>
                </a:gdLst>
                <a:ahLst/>
                <a:rect l="textAreaLeft" t="textAreaTop" r="textAreaRight" b="textAreaBottom"/>
                <a:pathLst>
                  <a:path w="212" h="892">
                    <a:moveTo>
                      <a:pt x="0" y="892"/>
                    </a:moveTo>
                    <a:lnTo>
                      <a:pt x="0" y="0"/>
                    </a:lnTo>
                    <a:lnTo>
                      <a:pt x="212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3" name="Rectangle 36"/>
              <p:cNvSpPr/>
              <p:nvPr/>
            </p:nvSpPr>
            <p:spPr>
              <a:xfrm>
                <a:off x="3953880" y="2260800"/>
                <a:ext cx="4899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 </a:t>
                </a: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Xenopus </a:t>
                </a:r>
                <a:r>
                  <a:rPr b="1" lang="el-GR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μ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4" name="Freeform 37"/>
              <p:cNvSpPr/>
              <p:nvPr/>
            </p:nvSpPr>
            <p:spPr>
              <a:xfrm>
                <a:off x="2317680" y="2328840"/>
                <a:ext cx="1631880" cy="92160"/>
              </a:xfrm>
              <a:custGeom>
                <a:avLst/>
                <a:gdLst>
                  <a:gd name="textAreaLeft" fmla="*/ 0 w 1631880"/>
                  <a:gd name="textAreaRight" fmla="*/ 1632240 w 1631880"/>
                  <a:gd name="textAreaTop" fmla="*/ 0 h 92160"/>
                  <a:gd name="textAreaBottom" fmla="*/ 92520 h 92160"/>
                </a:gdLst>
                <a:ahLst/>
                <a:rect l="textAreaLeft" t="textAreaTop" r="textAreaRight" b="textAreaBottom"/>
                <a:pathLst>
                  <a:path w="1028" h="58">
                    <a:moveTo>
                      <a:pt x="0" y="58"/>
                    </a:moveTo>
                    <a:lnTo>
                      <a:pt x="0" y="0"/>
                    </a:lnTo>
                    <a:lnTo>
                      <a:pt x="1028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5" name="Rectangle 38"/>
              <p:cNvSpPr/>
              <p:nvPr/>
            </p:nvSpPr>
            <p:spPr>
              <a:xfrm>
                <a:off x="4597920" y="2455920"/>
                <a:ext cx="473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 </a:t>
                </a: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Chicken </a:t>
                </a:r>
                <a:r>
                  <a:rPr b="1" lang="el-GR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μ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6" name="Freeform 39"/>
              <p:cNvSpPr/>
              <p:nvPr/>
            </p:nvSpPr>
            <p:spPr>
              <a:xfrm>
                <a:off x="2317680" y="2430720"/>
                <a:ext cx="2274840" cy="93600"/>
              </a:xfrm>
              <a:custGeom>
                <a:avLst/>
                <a:gdLst>
                  <a:gd name="textAreaLeft" fmla="*/ 0 w 2274840"/>
                  <a:gd name="textAreaRight" fmla="*/ 2274840 w 2274840"/>
                  <a:gd name="textAreaTop" fmla="*/ 0 h 93600"/>
                  <a:gd name="textAreaBottom" fmla="*/ 93960 h 93600"/>
                </a:gdLst>
                <a:ahLst/>
                <a:rect l="textAreaLeft" t="textAreaTop" r="textAreaRight" b="textAreaBottom"/>
                <a:pathLst>
                  <a:path w="1433" h="59">
                    <a:moveTo>
                      <a:pt x="0" y="0"/>
                    </a:moveTo>
                    <a:lnTo>
                      <a:pt x="0" y="59"/>
                    </a:lnTo>
                    <a:lnTo>
                      <a:pt x="1433" y="59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7" name="Freeform 40"/>
              <p:cNvSpPr/>
              <p:nvPr/>
            </p:nvSpPr>
            <p:spPr>
              <a:xfrm>
                <a:off x="1817640" y="2425680"/>
                <a:ext cx="500040" cy="374760"/>
              </a:xfrm>
              <a:custGeom>
                <a:avLst/>
                <a:gdLst>
                  <a:gd name="textAreaLeft" fmla="*/ 0 w 500040"/>
                  <a:gd name="textAreaRight" fmla="*/ 500400 w 500040"/>
                  <a:gd name="textAreaTop" fmla="*/ 0 h 374760"/>
                  <a:gd name="textAreaBottom" fmla="*/ 375120 h 374760"/>
                </a:gdLst>
                <a:ahLst/>
                <a:rect l="textAreaLeft" t="textAreaTop" r="textAreaRight" b="textAreaBottom"/>
                <a:pathLst>
                  <a:path w="315" h="236">
                    <a:moveTo>
                      <a:pt x="0" y="236"/>
                    </a:moveTo>
                    <a:lnTo>
                      <a:pt x="0" y="0"/>
                    </a:lnTo>
                    <a:lnTo>
                      <a:pt x="315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8" name="Rectangle 41"/>
              <p:cNvSpPr/>
              <p:nvPr/>
            </p:nvSpPr>
            <p:spPr>
              <a:xfrm>
                <a:off x="3944160" y="2651040"/>
                <a:ext cx="439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 </a:t>
                </a: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Human </a:t>
                </a:r>
                <a:r>
                  <a:rPr b="1" lang="el-GR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μ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9" name="Freeform 42"/>
              <p:cNvSpPr/>
              <p:nvPr/>
            </p:nvSpPr>
            <p:spPr>
              <a:xfrm>
                <a:off x="2693880" y="2719440"/>
                <a:ext cx="1246320" cy="93600"/>
              </a:xfrm>
              <a:custGeom>
                <a:avLst/>
                <a:gdLst>
                  <a:gd name="textAreaLeft" fmla="*/ 0 w 1246320"/>
                  <a:gd name="textAreaRight" fmla="*/ 1246320 w 1246320"/>
                  <a:gd name="textAreaTop" fmla="*/ 0 h 93600"/>
                  <a:gd name="textAreaBottom" fmla="*/ 93960 h 93600"/>
                </a:gdLst>
                <a:ahLst/>
                <a:rect l="textAreaLeft" t="textAreaTop" r="textAreaRight" b="textAreaBottom"/>
                <a:pathLst>
                  <a:path w="785" h="59">
                    <a:moveTo>
                      <a:pt x="0" y="59"/>
                    </a:moveTo>
                    <a:lnTo>
                      <a:pt x="0" y="0"/>
                    </a:lnTo>
                    <a:lnTo>
                      <a:pt x="785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0" name="Rectangle 43"/>
              <p:cNvSpPr/>
              <p:nvPr/>
            </p:nvSpPr>
            <p:spPr>
              <a:xfrm>
                <a:off x="3864960" y="2846520"/>
                <a:ext cx="3999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 </a:t>
                </a: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Mouse </a:t>
                </a:r>
                <a:r>
                  <a:rPr b="1" lang="el-GR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μ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1" name="Freeform 44"/>
              <p:cNvSpPr/>
              <p:nvPr/>
            </p:nvSpPr>
            <p:spPr>
              <a:xfrm>
                <a:off x="2693880" y="2820960"/>
                <a:ext cx="1168560" cy="93600"/>
              </a:xfrm>
              <a:custGeom>
                <a:avLst/>
                <a:gdLst>
                  <a:gd name="textAreaLeft" fmla="*/ 0 w 1168560"/>
                  <a:gd name="textAreaRight" fmla="*/ 1168920 w 1168560"/>
                  <a:gd name="textAreaTop" fmla="*/ 0 h 93600"/>
                  <a:gd name="textAreaBottom" fmla="*/ 93960 h 93600"/>
                </a:gdLst>
                <a:ahLst/>
                <a:rect l="textAreaLeft" t="textAreaTop" r="textAreaRight" b="textAreaBottom"/>
                <a:pathLst>
                  <a:path w="736" h="59">
                    <a:moveTo>
                      <a:pt x="0" y="0"/>
                    </a:moveTo>
                    <a:lnTo>
                      <a:pt x="0" y="59"/>
                    </a:lnTo>
                    <a:lnTo>
                      <a:pt x="736" y="59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2" name="Freeform 45"/>
              <p:cNvSpPr/>
              <p:nvPr/>
            </p:nvSpPr>
            <p:spPr>
              <a:xfrm>
                <a:off x="2079720" y="2816280"/>
                <a:ext cx="614160" cy="142920"/>
              </a:xfrm>
              <a:custGeom>
                <a:avLst/>
                <a:gdLst>
                  <a:gd name="textAreaLeft" fmla="*/ 0 w 614160"/>
                  <a:gd name="textAreaRight" fmla="*/ 614520 w 614160"/>
                  <a:gd name="textAreaTop" fmla="*/ 0 h 142920"/>
                  <a:gd name="textAreaBottom" fmla="*/ 143280 h 142920"/>
                </a:gdLst>
                <a:ahLst/>
                <a:rect l="textAreaLeft" t="textAreaTop" r="textAreaRight" b="textAreaBottom"/>
                <a:pathLst>
                  <a:path w="387" h="90">
                    <a:moveTo>
                      <a:pt x="0" y="90"/>
                    </a:moveTo>
                    <a:lnTo>
                      <a:pt x="0" y="0"/>
                    </a:lnTo>
                    <a:lnTo>
                      <a:pt x="387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3" name="Rectangle 46"/>
              <p:cNvSpPr/>
              <p:nvPr/>
            </p:nvSpPr>
            <p:spPr>
              <a:xfrm>
                <a:off x="3941280" y="3041640"/>
                <a:ext cx="5022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 </a:t>
                </a: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Lungfish </a:t>
                </a:r>
                <a:r>
                  <a:rPr b="1" lang="el-GR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μ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4" name="Freeform 47"/>
              <p:cNvSpPr/>
              <p:nvPr/>
            </p:nvSpPr>
            <p:spPr>
              <a:xfrm>
                <a:off x="2079720" y="2967120"/>
                <a:ext cx="1855800" cy="142920"/>
              </a:xfrm>
              <a:custGeom>
                <a:avLst/>
                <a:gdLst>
                  <a:gd name="textAreaLeft" fmla="*/ 0 w 1855800"/>
                  <a:gd name="textAreaRight" fmla="*/ 1855800 w 1855800"/>
                  <a:gd name="textAreaTop" fmla="*/ 0 h 142920"/>
                  <a:gd name="textAreaBottom" fmla="*/ 143280 h 142920"/>
                </a:gdLst>
                <a:ahLst/>
                <a:rect l="textAreaLeft" t="textAreaTop" r="textAreaRight" b="textAreaBottom"/>
                <a:pathLst>
                  <a:path w="1169" h="90">
                    <a:moveTo>
                      <a:pt x="0" y="0"/>
                    </a:moveTo>
                    <a:lnTo>
                      <a:pt x="0" y="90"/>
                    </a:lnTo>
                    <a:lnTo>
                      <a:pt x="1169" y="9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5" name="Freeform 48"/>
              <p:cNvSpPr/>
              <p:nvPr/>
            </p:nvSpPr>
            <p:spPr>
              <a:xfrm>
                <a:off x="1913040" y="2962440"/>
                <a:ext cx="166680" cy="215640"/>
              </a:xfrm>
              <a:custGeom>
                <a:avLst/>
                <a:gdLst>
                  <a:gd name="textAreaLeft" fmla="*/ 0 w 166680"/>
                  <a:gd name="textAreaRight" fmla="*/ 167040 w 166680"/>
                  <a:gd name="textAreaTop" fmla="*/ 0 h 215640"/>
                  <a:gd name="textAreaBottom" fmla="*/ 216000 h 215640"/>
                </a:gdLst>
                <a:ahLst/>
                <a:rect l="textAreaLeft" t="textAreaTop" r="textAreaRight" b="textAreaBottom"/>
                <a:pathLst>
                  <a:path w="105" h="136">
                    <a:moveTo>
                      <a:pt x="0" y="136"/>
                    </a:moveTo>
                    <a:lnTo>
                      <a:pt x="0" y="0"/>
                    </a:lnTo>
                    <a:lnTo>
                      <a:pt x="105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6" name="Rectangle 49"/>
              <p:cNvSpPr/>
              <p:nvPr/>
            </p:nvSpPr>
            <p:spPr>
              <a:xfrm>
                <a:off x="4017960" y="3237120"/>
                <a:ext cx="4381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 </a:t>
                </a: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Human </a:t>
                </a: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ＭＳ Ｐゴシック"/>
                  </a:rPr>
                  <a:t>α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7" name="Freeform 50"/>
              <p:cNvSpPr/>
              <p:nvPr/>
            </p:nvSpPr>
            <p:spPr>
              <a:xfrm>
                <a:off x="2077920" y="3305160"/>
                <a:ext cx="1935360" cy="93600"/>
              </a:xfrm>
              <a:custGeom>
                <a:avLst/>
                <a:gdLst>
                  <a:gd name="textAreaLeft" fmla="*/ 0 w 1935360"/>
                  <a:gd name="textAreaRight" fmla="*/ 1935720 w 1935360"/>
                  <a:gd name="textAreaTop" fmla="*/ 0 h 93600"/>
                  <a:gd name="textAreaBottom" fmla="*/ 93960 h 93600"/>
                </a:gdLst>
                <a:ahLst/>
                <a:rect l="textAreaLeft" t="textAreaTop" r="textAreaRight" b="textAreaBottom"/>
                <a:pathLst>
                  <a:path w="1219" h="59">
                    <a:moveTo>
                      <a:pt x="0" y="59"/>
                    </a:moveTo>
                    <a:lnTo>
                      <a:pt x="0" y="0"/>
                    </a:lnTo>
                    <a:lnTo>
                      <a:pt x="1219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8" name="Rectangle 51"/>
              <p:cNvSpPr/>
              <p:nvPr/>
            </p:nvSpPr>
            <p:spPr>
              <a:xfrm>
                <a:off x="4052520" y="3432240"/>
                <a:ext cx="340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 </a:t>
                </a: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Duck </a:t>
                </a:r>
                <a:r>
                  <a:rPr b="1" lang="el-GR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α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9" name="Freeform 52"/>
              <p:cNvSpPr/>
              <p:nvPr/>
            </p:nvSpPr>
            <p:spPr>
              <a:xfrm>
                <a:off x="2077920" y="3406680"/>
                <a:ext cx="1968480" cy="93960"/>
              </a:xfrm>
              <a:custGeom>
                <a:avLst/>
                <a:gdLst>
                  <a:gd name="textAreaLeft" fmla="*/ 0 w 1968480"/>
                  <a:gd name="textAreaRight" fmla="*/ 1968840 w 1968480"/>
                  <a:gd name="textAreaTop" fmla="*/ 0 h 93960"/>
                  <a:gd name="textAreaBottom" fmla="*/ 94320 h 93960"/>
                </a:gdLst>
                <a:ahLst/>
                <a:rect l="textAreaLeft" t="textAreaTop" r="textAreaRight" b="textAreaBottom"/>
                <a:pathLst>
                  <a:path w="1240" h="59">
                    <a:moveTo>
                      <a:pt x="0" y="0"/>
                    </a:moveTo>
                    <a:lnTo>
                      <a:pt x="0" y="59"/>
                    </a:lnTo>
                    <a:lnTo>
                      <a:pt x="1240" y="59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0" name="Freeform 53"/>
              <p:cNvSpPr/>
              <p:nvPr/>
            </p:nvSpPr>
            <p:spPr>
              <a:xfrm>
                <a:off x="1913040" y="3186360"/>
                <a:ext cx="164880" cy="215640"/>
              </a:xfrm>
              <a:custGeom>
                <a:avLst/>
                <a:gdLst>
                  <a:gd name="textAreaLeft" fmla="*/ 0 w 164880"/>
                  <a:gd name="textAreaRight" fmla="*/ 165240 w 164880"/>
                  <a:gd name="textAreaTop" fmla="*/ 0 h 215640"/>
                  <a:gd name="textAreaBottom" fmla="*/ 216000 h 215640"/>
                </a:gdLst>
                <a:ahLst/>
                <a:rect l="textAreaLeft" t="textAreaTop" r="textAreaRight" b="textAreaBottom"/>
                <a:pathLst>
                  <a:path w="104" h="136">
                    <a:moveTo>
                      <a:pt x="0" y="0"/>
                    </a:moveTo>
                    <a:lnTo>
                      <a:pt x="0" y="136"/>
                    </a:lnTo>
                    <a:lnTo>
                      <a:pt x="104" y="136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1" name="Freeform 54"/>
              <p:cNvSpPr/>
              <p:nvPr/>
            </p:nvSpPr>
            <p:spPr>
              <a:xfrm>
                <a:off x="1817640" y="2808360"/>
                <a:ext cx="95400" cy="374760"/>
              </a:xfrm>
              <a:custGeom>
                <a:avLst/>
                <a:gdLst>
                  <a:gd name="textAreaLeft" fmla="*/ 0 w 95400"/>
                  <a:gd name="textAreaRight" fmla="*/ 95760 w 95400"/>
                  <a:gd name="textAreaTop" fmla="*/ 0 h 374760"/>
                  <a:gd name="textAreaBottom" fmla="*/ 375120 h 374760"/>
                </a:gdLst>
                <a:ahLst/>
                <a:rect l="textAreaLeft" t="textAreaTop" r="textAreaRight" b="textAreaBottom"/>
                <a:pathLst>
                  <a:path w="60" h="236">
                    <a:moveTo>
                      <a:pt x="0" y="0"/>
                    </a:moveTo>
                    <a:lnTo>
                      <a:pt x="0" y="236"/>
                    </a:lnTo>
                    <a:lnTo>
                      <a:pt x="60" y="236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2" name="Freeform 55"/>
              <p:cNvSpPr/>
              <p:nvPr/>
            </p:nvSpPr>
            <p:spPr>
              <a:xfrm>
                <a:off x="1655640" y="2803680"/>
                <a:ext cx="162000" cy="490320"/>
              </a:xfrm>
              <a:custGeom>
                <a:avLst/>
                <a:gdLst>
                  <a:gd name="textAreaLeft" fmla="*/ 0 w 162000"/>
                  <a:gd name="textAreaRight" fmla="*/ 162360 w 162000"/>
                  <a:gd name="textAreaTop" fmla="*/ 0 h 490320"/>
                  <a:gd name="textAreaBottom" fmla="*/ 490680 h 490320"/>
                </a:gdLst>
                <a:ahLst/>
                <a:rect l="textAreaLeft" t="textAreaTop" r="textAreaRight" b="textAreaBottom"/>
                <a:pathLst>
                  <a:path w="102" h="309">
                    <a:moveTo>
                      <a:pt x="0" y="309"/>
                    </a:moveTo>
                    <a:lnTo>
                      <a:pt x="0" y="0"/>
                    </a:lnTo>
                    <a:lnTo>
                      <a:pt x="102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3" name="Rectangle 56"/>
              <p:cNvSpPr/>
              <p:nvPr/>
            </p:nvSpPr>
            <p:spPr>
              <a:xfrm>
                <a:off x="4146840" y="3627360"/>
                <a:ext cx="3772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 </a:t>
                </a: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Shark </a:t>
                </a:r>
                <a:r>
                  <a:rPr b="1" lang="el-GR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μ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4" name="Freeform 57"/>
              <p:cNvSpPr/>
              <p:nvPr/>
            </p:nvSpPr>
            <p:spPr>
              <a:xfrm>
                <a:off x="2546280" y="3695760"/>
                <a:ext cx="1596960" cy="93600"/>
              </a:xfrm>
              <a:custGeom>
                <a:avLst/>
                <a:gdLst>
                  <a:gd name="textAreaLeft" fmla="*/ 0 w 1596960"/>
                  <a:gd name="textAreaRight" fmla="*/ 1597320 w 1596960"/>
                  <a:gd name="textAreaTop" fmla="*/ 0 h 93600"/>
                  <a:gd name="textAreaBottom" fmla="*/ 93960 h 93600"/>
                </a:gdLst>
                <a:ahLst/>
                <a:rect l="textAreaLeft" t="textAreaTop" r="textAreaRight" b="textAreaBottom"/>
                <a:pathLst>
                  <a:path w="1006" h="59">
                    <a:moveTo>
                      <a:pt x="0" y="59"/>
                    </a:moveTo>
                    <a:lnTo>
                      <a:pt x="0" y="0"/>
                    </a:lnTo>
                    <a:lnTo>
                      <a:pt x="1006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5" name="Rectangle 58"/>
              <p:cNvSpPr/>
              <p:nvPr/>
            </p:nvSpPr>
            <p:spPr>
              <a:xfrm>
                <a:off x="4167360" y="3822840"/>
                <a:ext cx="354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 </a:t>
                </a: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Skate </a:t>
                </a:r>
                <a:r>
                  <a:rPr b="1" lang="el-GR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μ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6" name="Freeform 59"/>
              <p:cNvSpPr/>
              <p:nvPr/>
            </p:nvSpPr>
            <p:spPr>
              <a:xfrm>
                <a:off x="2546280" y="3797280"/>
                <a:ext cx="1617840" cy="93600"/>
              </a:xfrm>
              <a:custGeom>
                <a:avLst/>
                <a:gdLst>
                  <a:gd name="textAreaLeft" fmla="*/ 0 w 1617840"/>
                  <a:gd name="textAreaRight" fmla="*/ 1618200 w 1617840"/>
                  <a:gd name="textAreaTop" fmla="*/ 0 h 93600"/>
                  <a:gd name="textAreaBottom" fmla="*/ 93960 h 93600"/>
                </a:gdLst>
                <a:ahLst/>
                <a:rect l="textAreaLeft" t="textAreaTop" r="textAreaRight" b="textAreaBottom"/>
                <a:pathLst>
                  <a:path w="1019" h="59">
                    <a:moveTo>
                      <a:pt x="0" y="0"/>
                    </a:moveTo>
                    <a:lnTo>
                      <a:pt x="0" y="59"/>
                    </a:lnTo>
                    <a:lnTo>
                      <a:pt x="1019" y="59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7" name="Freeform 60"/>
              <p:cNvSpPr/>
              <p:nvPr/>
            </p:nvSpPr>
            <p:spPr>
              <a:xfrm>
                <a:off x="1655640" y="3301920"/>
                <a:ext cx="890640" cy="490680"/>
              </a:xfrm>
              <a:custGeom>
                <a:avLst/>
                <a:gdLst>
                  <a:gd name="textAreaLeft" fmla="*/ 0 w 890640"/>
                  <a:gd name="textAreaRight" fmla="*/ 891000 w 890640"/>
                  <a:gd name="textAreaTop" fmla="*/ 0 h 490680"/>
                  <a:gd name="textAreaBottom" fmla="*/ 491040 h 490680"/>
                </a:gdLst>
                <a:ahLst/>
                <a:rect l="textAreaLeft" t="textAreaTop" r="textAreaRight" b="textAreaBottom"/>
                <a:pathLst>
                  <a:path w="561" h="309">
                    <a:moveTo>
                      <a:pt x="0" y="0"/>
                    </a:moveTo>
                    <a:lnTo>
                      <a:pt x="0" y="309"/>
                    </a:lnTo>
                    <a:lnTo>
                      <a:pt x="561" y="309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8" name="Rectangle 61"/>
              <p:cNvSpPr/>
              <p:nvPr/>
            </p:nvSpPr>
            <p:spPr>
              <a:xfrm>
                <a:off x="4335840" y="4017960"/>
                <a:ext cx="4258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 </a:t>
                </a: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Human </a:t>
                </a: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ＭＳ Ｐゴシック"/>
                  </a:rPr>
                  <a:t>ε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9" name="Freeform 62"/>
              <p:cNvSpPr/>
              <p:nvPr/>
            </p:nvSpPr>
            <p:spPr>
              <a:xfrm>
                <a:off x="2608200" y="4086360"/>
                <a:ext cx="1724040" cy="93600"/>
              </a:xfrm>
              <a:custGeom>
                <a:avLst/>
                <a:gdLst>
                  <a:gd name="textAreaLeft" fmla="*/ 0 w 1724040"/>
                  <a:gd name="textAreaRight" fmla="*/ 1724400 w 1724040"/>
                  <a:gd name="textAreaTop" fmla="*/ 0 h 93600"/>
                  <a:gd name="textAreaBottom" fmla="*/ 93960 h 93600"/>
                </a:gdLst>
                <a:ahLst/>
                <a:rect l="textAreaLeft" t="textAreaTop" r="textAreaRight" b="textAreaBottom"/>
                <a:pathLst>
                  <a:path w="1086" h="59">
                    <a:moveTo>
                      <a:pt x="0" y="59"/>
                    </a:moveTo>
                    <a:lnTo>
                      <a:pt x="0" y="0"/>
                    </a:lnTo>
                    <a:lnTo>
                      <a:pt x="1086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0" name="Rectangle 63"/>
              <p:cNvSpPr/>
              <p:nvPr/>
            </p:nvSpPr>
            <p:spPr>
              <a:xfrm>
                <a:off x="4219920" y="4213440"/>
                <a:ext cx="505440" cy="2437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 </a:t>
                </a: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Opossum </a:t>
                </a: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ＭＳ Ｐゴシック"/>
                  </a:rPr>
                  <a:t>ε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 </a:t>
                </a:r>
                <a:r>
                  <a:rPr b="1" lang="ja-JP" sz="800" spc="-1" strike="noStrike">
                    <a:solidFill>
                      <a:srgbClr val="000000"/>
                    </a:solidFill>
                    <a:latin typeface="Times New Roman"/>
                    <a:ea typeface="ＭＳ Ｐゴシック"/>
                  </a:rPr>
                  <a:t>　</a:t>
                </a: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 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1" name="Freeform 64"/>
              <p:cNvSpPr/>
              <p:nvPr/>
            </p:nvSpPr>
            <p:spPr>
              <a:xfrm>
                <a:off x="2608200" y="4187880"/>
                <a:ext cx="1608120" cy="93600"/>
              </a:xfrm>
              <a:custGeom>
                <a:avLst/>
                <a:gdLst>
                  <a:gd name="textAreaLeft" fmla="*/ 0 w 1608120"/>
                  <a:gd name="textAreaRight" fmla="*/ 1608480 w 1608120"/>
                  <a:gd name="textAreaTop" fmla="*/ 0 h 93600"/>
                  <a:gd name="textAreaBottom" fmla="*/ 93960 h 93600"/>
                </a:gdLst>
                <a:ahLst/>
                <a:rect l="textAreaLeft" t="textAreaTop" r="textAreaRight" b="textAreaBottom"/>
                <a:pathLst>
                  <a:path w="1013" h="59">
                    <a:moveTo>
                      <a:pt x="0" y="0"/>
                    </a:moveTo>
                    <a:lnTo>
                      <a:pt x="0" y="59"/>
                    </a:lnTo>
                    <a:lnTo>
                      <a:pt x="1013" y="59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2" name="Freeform 65"/>
              <p:cNvSpPr/>
              <p:nvPr/>
            </p:nvSpPr>
            <p:spPr>
              <a:xfrm>
                <a:off x="1763640" y="4183200"/>
                <a:ext cx="844560" cy="216000"/>
              </a:xfrm>
              <a:custGeom>
                <a:avLst/>
                <a:gdLst>
                  <a:gd name="textAreaLeft" fmla="*/ 0 w 844560"/>
                  <a:gd name="textAreaRight" fmla="*/ 844920 w 844560"/>
                  <a:gd name="textAreaTop" fmla="*/ 0 h 216000"/>
                  <a:gd name="textAreaBottom" fmla="*/ 216360 h 216000"/>
                </a:gdLst>
                <a:ahLst/>
                <a:rect l="textAreaLeft" t="textAreaTop" r="textAreaRight" b="textAreaBottom"/>
                <a:pathLst>
                  <a:path w="532" h="136">
                    <a:moveTo>
                      <a:pt x="0" y="136"/>
                    </a:moveTo>
                    <a:lnTo>
                      <a:pt x="0" y="0"/>
                    </a:lnTo>
                    <a:lnTo>
                      <a:pt x="532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3" name="Rectangle 66"/>
              <p:cNvSpPr/>
              <p:nvPr/>
            </p:nvSpPr>
            <p:spPr>
              <a:xfrm>
                <a:off x="4183920" y="4408560"/>
                <a:ext cx="4852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 </a:t>
                </a: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Xenopus </a:t>
                </a: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ＭＳ Ｐゴシック"/>
                  </a:rPr>
                  <a:t>υ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4" name="Freeform 67"/>
              <p:cNvSpPr/>
              <p:nvPr/>
            </p:nvSpPr>
            <p:spPr>
              <a:xfrm>
                <a:off x="2093760" y="4476960"/>
                <a:ext cx="2086200" cy="142920"/>
              </a:xfrm>
              <a:custGeom>
                <a:avLst/>
                <a:gdLst>
                  <a:gd name="textAreaLeft" fmla="*/ 0 w 2086200"/>
                  <a:gd name="textAreaRight" fmla="*/ 2086560 w 2086200"/>
                  <a:gd name="textAreaTop" fmla="*/ 0 h 142920"/>
                  <a:gd name="textAreaBottom" fmla="*/ 143280 h 142920"/>
                </a:gdLst>
                <a:ahLst/>
                <a:rect l="textAreaLeft" t="textAreaTop" r="textAreaRight" b="textAreaBottom"/>
                <a:pathLst>
                  <a:path w="1314" h="90">
                    <a:moveTo>
                      <a:pt x="0" y="90"/>
                    </a:moveTo>
                    <a:lnTo>
                      <a:pt x="0" y="0"/>
                    </a:lnTo>
                    <a:lnTo>
                      <a:pt x="1314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5" name="Rectangle 68"/>
              <p:cNvSpPr/>
              <p:nvPr/>
            </p:nvSpPr>
            <p:spPr>
              <a:xfrm>
                <a:off x="3903120" y="4603680"/>
                <a:ext cx="4806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 </a:t>
                </a: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Human </a:t>
                </a: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ＭＳ Ｐゴシック"/>
                  </a:rPr>
                  <a:t>γ</a:t>
                </a: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1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6" name="Freeform 69"/>
              <p:cNvSpPr/>
              <p:nvPr/>
            </p:nvSpPr>
            <p:spPr>
              <a:xfrm>
                <a:off x="2936880" y="4672080"/>
                <a:ext cx="961920" cy="93600"/>
              </a:xfrm>
              <a:custGeom>
                <a:avLst/>
                <a:gdLst>
                  <a:gd name="textAreaLeft" fmla="*/ 0 w 961920"/>
                  <a:gd name="textAreaRight" fmla="*/ 962280 w 961920"/>
                  <a:gd name="textAreaTop" fmla="*/ 0 h 93600"/>
                  <a:gd name="textAreaBottom" fmla="*/ 93960 h 93600"/>
                </a:gdLst>
                <a:ahLst/>
                <a:rect l="textAreaLeft" t="textAreaTop" r="textAreaRight" b="textAreaBottom"/>
                <a:pathLst>
                  <a:path w="606" h="59">
                    <a:moveTo>
                      <a:pt x="0" y="59"/>
                    </a:moveTo>
                    <a:lnTo>
                      <a:pt x="0" y="0"/>
                    </a:lnTo>
                    <a:lnTo>
                      <a:pt x="606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7" name="Rectangle 70"/>
              <p:cNvSpPr/>
              <p:nvPr/>
            </p:nvSpPr>
            <p:spPr>
              <a:xfrm>
                <a:off x="4275000" y="4799160"/>
                <a:ext cx="4410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 </a:t>
                </a: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Mouse </a:t>
                </a: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ＭＳ Ｐゴシック"/>
                  </a:rPr>
                  <a:t>γ</a:t>
                </a: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3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8" name="Freeform 71"/>
              <p:cNvSpPr/>
              <p:nvPr/>
            </p:nvSpPr>
            <p:spPr>
              <a:xfrm>
                <a:off x="2936880" y="4773600"/>
                <a:ext cx="1333440" cy="93600"/>
              </a:xfrm>
              <a:custGeom>
                <a:avLst/>
                <a:gdLst>
                  <a:gd name="textAreaLeft" fmla="*/ 0 w 1333440"/>
                  <a:gd name="textAreaRight" fmla="*/ 1333800 w 1333440"/>
                  <a:gd name="textAreaTop" fmla="*/ 0 h 93600"/>
                  <a:gd name="textAreaBottom" fmla="*/ 93960 h 93600"/>
                </a:gdLst>
                <a:ahLst/>
                <a:rect l="textAreaLeft" t="textAreaTop" r="textAreaRight" b="textAreaBottom"/>
                <a:pathLst>
                  <a:path w="840" h="59">
                    <a:moveTo>
                      <a:pt x="0" y="0"/>
                    </a:moveTo>
                    <a:lnTo>
                      <a:pt x="0" y="59"/>
                    </a:lnTo>
                    <a:lnTo>
                      <a:pt x="840" y="59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9" name="Freeform 72"/>
              <p:cNvSpPr/>
              <p:nvPr/>
            </p:nvSpPr>
            <p:spPr>
              <a:xfrm>
                <a:off x="2093760" y="4627800"/>
                <a:ext cx="843120" cy="142560"/>
              </a:xfrm>
              <a:custGeom>
                <a:avLst/>
                <a:gdLst>
                  <a:gd name="textAreaLeft" fmla="*/ 0 w 843120"/>
                  <a:gd name="textAreaRight" fmla="*/ 843480 w 843120"/>
                  <a:gd name="textAreaTop" fmla="*/ 0 h 142560"/>
                  <a:gd name="textAreaBottom" fmla="*/ 142920 h 142560"/>
                </a:gdLst>
                <a:ahLst/>
                <a:rect l="textAreaLeft" t="textAreaTop" r="textAreaRight" b="textAreaBottom"/>
                <a:pathLst>
                  <a:path w="531" h="90">
                    <a:moveTo>
                      <a:pt x="0" y="0"/>
                    </a:moveTo>
                    <a:lnTo>
                      <a:pt x="0" y="90"/>
                    </a:lnTo>
                    <a:lnTo>
                      <a:pt x="531" y="9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0" name="Freeform 73"/>
              <p:cNvSpPr/>
              <p:nvPr/>
            </p:nvSpPr>
            <p:spPr>
              <a:xfrm>
                <a:off x="1763640" y="4407120"/>
                <a:ext cx="330120" cy="215640"/>
              </a:xfrm>
              <a:custGeom>
                <a:avLst/>
                <a:gdLst>
                  <a:gd name="textAreaLeft" fmla="*/ 0 w 330120"/>
                  <a:gd name="textAreaRight" fmla="*/ 330480 w 330120"/>
                  <a:gd name="textAreaTop" fmla="*/ 0 h 215640"/>
                  <a:gd name="textAreaBottom" fmla="*/ 216000 h 215640"/>
                </a:gdLst>
                <a:ahLst/>
                <a:rect l="textAreaLeft" t="textAreaTop" r="textAreaRight" b="textAreaBottom"/>
                <a:pathLst>
                  <a:path w="208" h="136">
                    <a:moveTo>
                      <a:pt x="0" y="0"/>
                    </a:moveTo>
                    <a:lnTo>
                      <a:pt x="0" y="136"/>
                    </a:lnTo>
                    <a:lnTo>
                      <a:pt x="208" y="136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1" name="Freeform 74"/>
              <p:cNvSpPr/>
              <p:nvPr/>
            </p:nvSpPr>
            <p:spPr>
              <a:xfrm>
                <a:off x="1655640" y="3608640"/>
                <a:ext cx="108000" cy="795240"/>
              </a:xfrm>
              <a:custGeom>
                <a:avLst/>
                <a:gdLst>
                  <a:gd name="textAreaLeft" fmla="*/ 0 w 108000"/>
                  <a:gd name="textAreaRight" fmla="*/ 108360 w 108000"/>
                  <a:gd name="textAreaTop" fmla="*/ 0 h 795240"/>
                  <a:gd name="textAreaBottom" fmla="*/ 795600 h 795240"/>
                </a:gdLst>
                <a:ahLst/>
                <a:rect l="textAreaLeft" t="textAreaTop" r="textAreaRight" b="textAreaBottom"/>
                <a:pathLst>
                  <a:path w="68" h="501">
                    <a:moveTo>
                      <a:pt x="0" y="0"/>
                    </a:moveTo>
                    <a:lnTo>
                      <a:pt x="0" y="501"/>
                    </a:lnTo>
                    <a:lnTo>
                      <a:pt x="68" y="501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2" name="Line 75"/>
              <p:cNvSpPr/>
              <p:nvPr/>
            </p:nvSpPr>
            <p:spPr>
              <a:xfrm>
                <a:off x="1655640" y="2803680"/>
                <a:ext cx="1800" cy="79668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3" name="Freeform 76"/>
              <p:cNvSpPr/>
              <p:nvPr/>
            </p:nvSpPr>
            <p:spPr>
              <a:xfrm>
                <a:off x="1619280" y="3603600"/>
                <a:ext cx="36360" cy="798480"/>
              </a:xfrm>
              <a:custGeom>
                <a:avLst/>
                <a:gdLst>
                  <a:gd name="textAreaLeft" fmla="*/ 0 w 36360"/>
                  <a:gd name="textAreaRight" fmla="*/ 36720 w 36360"/>
                  <a:gd name="textAreaTop" fmla="*/ 0 h 798480"/>
                  <a:gd name="textAreaBottom" fmla="*/ 798840 h 798480"/>
                </a:gdLst>
                <a:ahLst/>
                <a:rect l="textAreaLeft" t="textAreaTop" r="textAreaRight" b="textAreaBottom"/>
                <a:pathLst>
                  <a:path w="23" h="503">
                    <a:moveTo>
                      <a:pt x="0" y="503"/>
                    </a:moveTo>
                    <a:lnTo>
                      <a:pt x="0" y="0"/>
                    </a:lnTo>
                    <a:lnTo>
                      <a:pt x="23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4" name="Rectangle 77"/>
              <p:cNvSpPr/>
              <p:nvPr/>
            </p:nvSpPr>
            <p:spPr>
              <a:xfrm>
                <a:off x="4306320" y="4996080"/>
                <a:ext cx="6120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 </a:t>
                </a: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Shark NARC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5" name="Freeform 78"/>
              <p:cNvSpPr/>
              <p:nvPr/>
            </p:nvSpPr>
            <p:spPr>
              <a:xfrm>
                <a:off x="2612880" y="5062680"/>
                <a:ext cx="1627200" cy="142920"/>
              </a:xfrm>
              <a:custGeom>
                <a:avLst/>
                <a:gdLst>
                  <a:gd name="textAreaLeft" fmla="*/ 0 w 1627200"/>
                  <a:gd name="textAreaRight" fmla="*/ 1627560 w 1627200"/>
                  <a:gd name="textAreaTop" fmla="*/ 0 h 142920"/>
                  <a:gd name="textAreaBottom" fmla="*/ 143280 h 142920"/>
                </a:gdLst>
                <a:ahLst/>
                <a:rect l="textAreaLeft" t="textAreaTop" r="textAreaRight" b="textAreaBottom"/>
                <a:pathLst>
                  <a:path w="1025" h="90">
                    <a:moveTo>
                      <a:pt x="0" y="90"/>
                    </a:moveTo>
                    <a:lnTo>
                      <a:pt x="0" y="0"/>
                    </a:lnTo>
                    <a:lnTo>
                      <a:pt x="1025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6" name="Rectangle 79"/>
              <p:cNvSpPr/>
              <p:nvPr/>
            </p:nvSpPr>
            <p:spPr>
              <a:xfrm>
                <a:off x="4129920" y="5191200"/>
                <a:ext cx="393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 </a:t>
                </a: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Shark </a:t>
                </a: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ＭＳ Ｐゴシック"/>
                  </a:rPr>
                  <a:t>ω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7" name="Freeform 80"/>
              <p:cNvSpPr/>
              <p:nvPr/>
            </p:nvSpPr>
            <p:spPr>
              <a:xfrm>
                <a:off x="3338640" y="5257800"/>
                <a:ext cx="785520" cy="93600"/>
              </a:xfrm>
              <a:custGeom>
                <a:avLst/>
                <a:gdLst>
                  <a:gd name="textAreaLeft" fmla="*/ 0 w 785520"/>
                  <a:gd name="textAreaRight" fmla="*/ 785880 w 785520"/>
                  <a:gd name="textAreaTop" fmla="*/ 0 h 93600"/>
                  <a:gd name="textAreaBottom" fmla="*/ 93960 h 93600"/>
                </a:gdLst>
                <a:ahLst/>
                <a:rect l="textAreaLeft" t="textAreaTop" r="textAreaRight" b="textAreaBottom"/>
                <a:pathLst>
                  <a:path w="495" h="59">
                    <a:moveTo>
                      <a:pt x="0" y="59"/>
                    </a:moveTo>
                    <a:lnTo>
                      <a:pt x="0" y="0"/>
                    </a:lnTo>
                    <a:lnTo>
                      <a:pt x="495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8" name="Rectangle 81"/>
              <p:cNvSpPr/>
              <p:nvPr/>
            </p:nvSpPr>
            <p:spPr>
              <a:xfrm>
                <a:off x="4221720" y="5386320"/>
                <a:ext cx="538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 </a:t>
                </a: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Shark NAR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9" name="Freeform 82"/>
              <p:cNvSpPr/>
              <p:nvPr/>
            </p:nvSpPr>
            <p:spPr>
              <a:xfrm>
                <a:off x="3338640" y="5359320"/>
                <a:ext cx="822240" cy="93960"/>
              </a:xfrm>
              <a:custGeom>
                <a:avLst/>
                <a:gdLst>
                  <a:gd name="textAreaLeft" fmla="*/ 0 w 822240"/>
                  <a:gd name="textAreaRight" fmla="*/ 822600 w 822240"/>
                  <a:gd name="textAreaTop" fmla="*/ 0 h 93960"/>
                  <a:gd name="textAreaBottom" fmla="*/ 94320 h 93960"/>
                </a:gdLst>
                <a:ahLst/>
                <a:rect l="textAreaLeft" t="textAreaTop" r="textAreaRight" b="textAreaBottom"/>
                <a:pathLst>
                  <a:path w="518" h="59">
                    <a:moveTo>
                      <a:pt x="0" y="0"/>
                    </a:moveTo>
                    <a:lnTo>
                      <a:pt x="0" y="59"/>
                    </a:lnTo>
                    <a:lnTo>
                      <a:pt x="518" y="59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0" name="Freeform 83"/>
              <p:cNvSpPr/>
              <p:nvPr/>
            </p:nvSpPr>
            <p:spPr>
              <a:xfrm>
                <a:off x="2612880" y="5213520"/>
                <a:ext cx="725760" cy="142920"/>
              </a:xfrm>
              <a:custGeom>
                <a:avLst/>
                <a:gdLst>
                  <a:gd name="textAreaLeft" fmla="*/ 0 w 725760"/>
                  <a:gd name="textAreaRight" fmla="*/ 726120 w 725760"/>
                  <a:gd name="textAreaTop" fmla="*/ 0 h 142920"/>
                  <a:gd name="textAreaBottom" fmla="*/ 143280 h 142920"/>
                </a:gdLst>
                <a:ahLst/>
                <a:rect l="textAreaLeft" t="textAreaTop" r="textAreaRight" b="textAreaBottom"/>
                <a:pathLst>
                  <a:path w="457" h="90">
                    <a:moveTo>
                      <a:pt x="0" y="0"/>
                    </a:moveTo>
                    <a:lnTo>
                      <a:pt x="0" y="90"/>
                    </a:lnTo>
                    <a:lnTo>
                      <a:pt x="457" y="9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1" name="Freeform 84"/>
              <p:cNvSpPr/>
              <p:nvPr/>
            </p:nvSpPr>
            <p:spPr>
              <a:xfrm>
                <a:off x="1619280" y="4410000"/>
                <a:ext cx="993600" cy="798840"/>
              </a:xfrm>
              <a:custGeom>
                <a:avLst/>
                <a:gdLst>
                  <a:gd name="textAreaLeft" fmla="*/ 0 w 993600"/>
                  <a:gd name="textAreaRight" fmla="*/ 993960 w 993600"/>
                  <a:gd name="textAreaTop" fmla="*/ 0 h 798840"/>
                  <a:gd name="textAreaBottom" fmla="*/ 799200 h 798840"/>
                </a:gdLst>
                <a:ahLst/>
                <a:rect l="textAreaLeft" t="textAreaTop" r="textAreaRight" b="textAreaBottom"/>
                <a:pathLst>
                  <a:path w="626" h="503">
                    <a:moveTo>
                      <a:pt x="0" y="0"/>
                    </a:moveTo>
                    <a:lnTo>
                      <a:pt x="0" y="503"/>
                    </a:lnTo>
                    <a:lnTo>
                      <a:pt x="626" y="503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2" name="Freeform 85"/>
              <p:cNvSpPr/>
              <p:nvPr/>
            </p:nvSpPr>
            <p:spPr>
              <a:xfrm>
                <a:off x="1525680" y="2989440"/>
                <a:ext cx="93600" cy="1415880"/>
              </a:xfrm>
              <a:custGeom>
                <a:avLst/>
                <a:gdLst>
                  <a:gd name="textAreaLeft" fmla="*/ 0 w 93600"/>
                  <a:gd name="textAreaRight" fmla="*/ 93960 w 93600"/>
                  <a:gd name="textAreaTop" fmla="*/ 0 h 1415880"/>
                  <a:gd name="textAreaBottom" fmla="*/ 1415880 h 1415880"/>
                </a:gdLst>
                <a:ahLst/>
                <a:rect l="textAreaLeft" t="textAreaTop" r="textAreaRight" b="textAreaBottom"/>
                <a:pathLst>
                  <a:path w="59" h="892">
                    <a:moveTo>
                      <a:pt x="0" y="0"/>
                    </a:moveTo>
                    <a:lnTo>
                      <a:pt x="0" y="892"/>
                    </a:lnTo>
                    <a:lnTo>
                      <a:pt x="59" y="892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3" name="Freeform 86"/>
              <p:cNvSpPr/>
              <p:nvPr/>
            </p:nvSpPr>
            <p:spPr>
              <a:xfrm>
                <a:off x="1444680" y="2986200"/>
                <a:ext cx="81000" cy="1698480"/>
              </a:xfrm>
              <a:custGeom>
                <a:avLst/>
                <a:gdLst>
                  <a:gd name="textAreaLeft" fmla="*/ 0 w 81000"/>
                  <a:gd name="textAreaRight" fmla="*/ 81360 w 81000"/>
                  <a:gd name="textAreaTop" fmla="*/ 0 h 1698480"/>
                  <a:gd name="textAreaBottom" fmla="*/ 1698840 h 1698480"/>
                </a:gdLst>
                <a:ahLst/>
                <a:rect l="textAreaLeft" t="textAreaTop" r="textAreaRight" b="textAreaBottom"/>
                <a:pathLst>
                  <a:path w="51" h="1070">
                    <a:moveTo>
                      <a:pt x="0" y="1070"/>
                    </a:moveTo>
                    <a:lnTo>
                      <a:pt x="0" y="0"/>
                    </a:lnTo>
                    <a:lnTo>
                      <a:pt x="51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4" name="Rectangle 87"/>
              <p:cNvSpPr/>
              <p:nvPr/>
            </p:nvSpPr>
            <p:spPr>
              <a:xfrm>
                <a:off x="4273200" y="5581800"/>
                <a:ext cx="837360" cy="138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 </a:t>
                </a: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Atlantic salmon </a:t>
                </a: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ＭＳ Ｐゴシック"/>
                  </a:rPr>
                  <a:t>δ</a:t>
                </a:r>
                <a:r>
                  <a:rPr b="1" lang="en-US" sz="800" spc="-1" strike="noStrike" baseline="-25000">
                    <a:solidFill>
                      <a:srgbClr val="000000"/>
                    </a:solidFill>
                    <a:latin typeface="Times New Roman"/>
                    <a:ea typeface="Arial"/>
                  </a:rPr>
                  <a:t>B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5" name="Freeform 88"/>
              <p:cNvSpPr/>
              <p:nvPr/>
            </p:nvSpPr>
            <p:spPr>
              <a:xfrm>
                <a:off x="4254480" y="5648400"/>
                <a:ext cx="1440" cy="93600"/>
              </a:xfrm>
              <a:custGeom>
                <a:avLst/>
                <a:gdLst>
                  <a:gd name="textAreaLeft" fmla="*/ 0 w 1440"/>
                  <a:gd name="textAreaRight" fmla="*/ 1800 w 1440"/>
                  <a:gd name="textAreaTop" fmla="*/ 0 h 93600"/>
                  <a:gd name="textAreaBottom" fmla="*/ 93960 h 93600"/>
                </a:gdLst>
                <a:ahLst/>
                <a:rect l="textAreaLeft" t="textAreaTop" r="textAreaRight" b="textAreaBottom"/>
                <a:pathLst>
                  <a:path w="1" h="59">
                    <a:moveTo>
                      <a:pt x="0" y="59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6" name="Rectangle 89"/>
              <p:cNvSpPr/>
              <p:nvPr/>
            </p:nvSpPr>
            <p:spPr>
              <a:xfrm>
                <a:off x="4273920" y="5776920"/>
                <a:ext cx="840600" cy="138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 </a:t>
                </a: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Atlantic salmon </a:t>
                </a: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ＭＳ Ｐゴシック"/>
                  </a:rPr>
                  <a:t>δ</a:t>
                </a:r>
                <a:r>
                  <a:rPr b="1" lang="en-US" sz="800" spc="-1" strike="noStrike" baseline="-25000">
                    <a:solidFill>
                      <a:srgbClr val="000000"/>
                    </a:solidFill>
                    <a:latin typeface="Times New Roman"/>
                    <a:ea typeface="Arial"/>
                  </a:rPr>
                  <a:t>A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7" name="Freeform 90"/>
              <p:cNvSpPr/>
              <p:nvPr/>
            </p:nvSpPr>
            <p:spPr>
              <a:xfrm>
                <a:off x="4254480" y="5749920"/>
                <a:ext cx="1440" cy="93600"/>
              </a:xfrm>
              <a:custGeom>
                <a:avLst/>
                <a:gdLst>
                  <a:gd name="textAreaLeft" fmla="*/ 0 w 1440"/>
                  <a:gd name="textAreaRight" fmla="*/ 1800 w 1440"/>
                  <a:gd name="textAreaTop" fmla="*/ 0 h 93600"/>
                  <a:gd name="textAreaBottom" fmla="*/ 93960 h 93600"/>
                </a:gdLst>
                <a:ahLst/>
                <a:rect l="textAreaLeft" t="textAreaTop" r="textAreaRight" b="textAreaBottom"/>
                <a:pathLst>
                  <a:path w="1" h="59">
                    <a:moveTo>
                      <a:pt x="0" y="0"/>
                    </a:moveTo>
                    <a:lnTo>
                      <a:pt x="0" y="59"/>
                    </a:lnTo>
                    <a:lnTo>
                      <a:pt x="0" y="59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8" name="Freeform 91"/>
              <p:cNvSpPr/>
              <p:nvPr/>
            </p:nvSpPr>
            <p:spPr>
              <a:xfrm>
                <a:off x="2490840" y="5746680"/>
                <a:ext cx="1763640" cy="142920"/>
              </a:xfrm>
              <a:custGeom>
                <a:avLst/>
                <a:gdLst>
                  <a:gd name="textAreaLeft" fmla="*/ 0 w 1763640"/>
                  <a:gd name="textAreaRight" fmla="*/ 1764000 w 1763640"/>
                  <a:gd name="textAreaTop" fmla="*/ 0 h 142920"/>
                  <a:gd name="textAreaBottom" fmla="*/ 143280 h 142920"/>
                </a:gdLst>
                <a:ahLst/>
                <a:rect l="textAreaLeft" t="textAreaTop" r="textAreaRight" b="textAreaBottom"/>
                <a:pathLst>
                  <a:path w="1111" h="90">
                    <a:moveTo>
                      <a:pt x="0" y="90"/>
                    </a:moveTo>
                    <a:lnTo>
                      <a:pt x="0" y="0"/>
                    </a:lnTo>
                    <a:lnTo>
                      <a:pt x="1111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9" name="Rectangle 92"/>
              <p:cNvSpPr/>
              <p:nvPr/>
            </p:nvSpPr>
            <p:spPr>
              <a:xfrm>
                <a:off x="4291200" y="5972400"/>
                <a:ext cx="3330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 </a:t>
                </a: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Fugu </a:t>
                </a:r>
                <a:r>
                  <a:rPr b="1" lang="el-GR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δ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0" name="Freeform 93"/>
              <p:cNvSpPr/>
              <p:nvPr/>
            </p:nvSpPr>
            <p:spPr>
              <a:xfrm>
                <a:off x="2490840" y="5897520"/>
                <a:ext cx="1797120" cy="141480"/>
              </a:xfrm>
              <a:custGeom>
                <a:avLst/>
                <a:gdLst>
                  <a:gd name="textAreaLeft" fmla="*/ 0 w 1797120"/>
                  <a:gd name="textAreaRight" fmla="*/ 1797480 w 1797120"/>
                  <a:gd name="textAreaTop" fmla="*/ 0 h 141480"/>
                  <a:gd name="textAreaBottom" fmla="*/ 141840 h 141480"/>
                </a:gdLst>
                <a:ahLst/>
                <a:rect l="textAreaLeft" t="textAreaTop" r="textAreaRight" b="textAreaBottom"/>
                <a:pathLst>
                  <a:path w="1132" h="89">
                    <a:moveTo>
                      <a:pt x="0" y="0"/>
                    </a:moveTo>
                    <a:lnTo>
                      <a:pt x="0" y="89"/>
                    </a:lnTo>
                    <a:lnTo>
                      <a:pt x="1132" y="89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1" name="Freeform 94"/>
              <p:cNvSpPr/>
              <p:nvPr/>
            </p:nvSpPr>
            <p:spPr>
              <a:xfrm>
                <a:off x="2103480" y="5892840"/>
                <a:ext cx="387360" cy="166680"/>
              </a:xfrm>
              <a:custGeom>
                <a:avLst/>
                <a:gdLst>
                  <a:gd name="textAreaLeft" fmla="*/ 0 w 387360"/>
                  <a:gd name="textAreaRight" fmla="*/ 387720 w 387360"/>
                  <a:gd name="textAreaTop" fmla="*/ 0 h 166680"/>
                  <a:gd name="textAreaBottom" fmla="*/ 167040 h 166680"/>
                </a:gdLst>
                <a:ahLst/>
                <a:rect l="textAreaLeft" t="textAreaTop" r="textAreaRight" b="textAreaBottom"/>
                <a:pathLst>
                  <a:path w="244" h="105">
                    <a:moveTo>
                      <a:pt x="0" y="105"/>
                    </a:moveTo>
                    <a:lnTo>
                      <a:pt x="0" y="0"/>
                    </a:lnTo>
                    <a:lnTo>
                      <a:pt x="244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2" name="Rectangle 95"/>
              <p:cNvSpPr/>
              <p:nvPr/>
            </p:nvSpPr>
            <p:spPr>
              <a:xfrm>
                <a:off x="4197240" y="6167520"/>
                <a:ext cx="5324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 </a:t>
                </a: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Zebrafish </a:t>
                </a:r>
                <a:r>
                  <a:rPr b="1" lang="el-GR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δ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3" name="Freeform 96"/>
              <p:cNvSpPr/>
              <p:nvPr/>
            </p:nvSpPr>
            <p:spPr>
              <a:xfrm>
                <a:off x="2103480" y="6067440"/>
                <a:ext cx="2090520" cy="166680"/>
              </a:xfrm>
              <a:custGeom>
                <a:avLst/>
                <a:gdLst>
                  <a:gd name="textAreaLeft" fmla="*/ 0 w 2090520"/>
                  <a:gd name="textAreaRight" fmla="*/ 2090880 w 2090520"/>
                  <a:gd name="textAreaTop" fmla="*/ 0 h 166680"/>
                  <a:gd name="textAreaBottom" fmla="*/ 167040 h 166680"/>
                </a:gdLst>
                <a:ahLst/>
                <a:rect l="textAreaLeft" t="textAreaTop" r="textAreaRight" b="textAreaBottom"/>
                <a:pathLst>
                  <a:path w="1317" h="105">
                    <a:moveTo>
                      <a:pt x="0" y="0"/>
                    </a:moveTo>
                    <a:lnTo>
                      <a:pt x="0" y="105"/>
                    </a:lnTo>
                    <a:lnTo>
                      <a:pt x="1317" y="105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4" name="Rectangle 97"/>
              <p:cNvSpPr/>
              <p:nvPr/>
            </p:nvSpPr>
            <p:spPr>
              <a:xfrm>
                <a:off x="4129560" y="6362640"/>
                <a:ext cx="4230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 </a:t>
                </a: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Catfish </a:t>
                </a:r>
                <a:r>
                  <a:rPr b="1" lang="el-GR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δ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5" name="Freeform 98"/>
              <p:cNvSpPr/>
              <p:nvPr/>
            </p:nvSpPr>
            <p:spPr>
              <a:xfrm>
                <a:off x="2103480" y="6166080"/>
                <a:ext cx="2020680" cy="264960"/>
              </a:xfrm>
              <a:custGeom>
                <a:avLst/>
                <a:gdLst>
                  <a:gd name="textAreaLeft" fmla="*/ 0 w 2020680"/>
                  <a:gd name="textAreaRight" fmla="*/ 2020680 w 2020680"/>
                  <a:gd name="textAreaTop" fmla="*/ 0 h 264960"/>
                  <a:gd name="textAreaBottom" fmla="*/ 265320 h 264960"/>
                </a:gdLst>
                <a:ahLst/>
                <a:rect l="textAreaLeft" t="textAreaTop" r="textAreaRight" b="textAreaBottom"/>
                <a:pathLst>
                  <a:path w="1273" h="167">
                    <a:moveTo>
                      <a:pt x="0" y="0"/>
                    </a:moveTo>
                    <a:lnTo>
                      <a:pt x="0" y="167"/>
                    </a:lnTo>
                    <a:lnTo>
                      <a:pt x="1273" y="167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6" name="Line 99"/>
              <p:cNvSpPr/>
              <p:nvPr/>
            </p:nvSpPr>
            <p:spPr>
              <a:xfrm>
                <a:off x="2103480" y="5892840"/>
                <a:ext cx="1440" cy="26532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7" name="Freeform 100"/>
              <p:cNvSpPr/>
              <p:nvPr/>
            </p:nvSpPr>
            <p:spPr>
              <a:xfrm>
                <a:off x="1631880" y="6161040"/>
                <a:ext cx="471600" cy="228600"/>
              </a:xfrm>
              <a:custGeom>
                <a:avLst/>
                <a:gdLst>
                  <a:gd name="textAreaLeft" fmla="*/ 0 w 471600"/>
                  <a:gd name="textAreaRight" fmla="*/ 471960 w 471600"/>
                  <a:gd name="textAreaTop" fmla="*/ 0 h 228600"/>
                  <a:gd name="textAreaBottom" fmla="*/ 228960 h 228600"/>
                </a:gdLst>
                <a:ahLst/>
                <a:rect l="textAreaLeft" t="textAreaTop" r="textAreaRight" b="textAreaBottom"/>
                <a:pathLst>
                  <a:path w="297" h="144">
                    <a:moveTo>
                      <a:pt x="0" y="144"/>
                    </a:moveTo>
                    <a:lnTo>
                      <a:pt x="0" y="0"/>
                    </a:lnTo>
                    <a:lnTo>
                      <a:pt x="297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8" name="Rectangle 101"/>
              <p:cNvSpPr/>
              <p:nvPr/>
            </p:nvSpPr>
            <p:spPr>
              <a:xfrm>
                <a:off x="4259880" y="6558120"/>
                <a:ext cx="4348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 </a:t>
                </a: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Human </a:t>
                </a:r>
                <a:r>
                  <a:rPr b="1" lang="el-GR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δ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9" name="Freeform 102"/>
              <p:cNvSpPr/>
              <p:nvPr/>
            </p:nvSpPr>
            <p:spPr>
              <a:xfrm>
                <a:off x="1631880" y="6397560"/>
                <a:ext cx="2622600" cy="228600"/>
              </a:xfrm>
              <a:custGeom>
                <a:avLst/>
                <a:gdLst>
                  <a:gd name="textAreaLeft" fmla="*/ 0 w 2622600"/>
                  <a:gd name="textAreaRight" fmla="*/ 2622960 w 2622600"/>
                  <a:gd name="textAreaTop" fmla="*/ 0 h 228600"/>
                  <a:gd name="textAreaBottom" fmla="*/ 228960 h 228600"/>
                </a:gdLst>
                <a:ahLst/>
                <a:rect l="textAreaLeft" t="textAreaTop" r="textAreaRight" b="textAreaBottom"/>
                <a:pathLst>
                  <a:path w="1652" h="144">
                    <a:moveTo>
                      <a:pt x="0" y="0"/>
                    </a:moveTo>
                    <a:lnTo>
                      <a:pt x="0" y="144"/>
                    </a:lnTo>
                    <a:lnTo>
                      <a:pt x="1652" y="144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40" name="Freeform 103"/>
              <p:cNvSpPr/>
              <p:nvPr/>
            </p:nvSpPr>
            <p:spPr>
              <a:xfrm>
                <a:off x="1444680" y="4692600"/>
                <a:ext cx="187200" cy="1700280"/>
              </a:xfrm>
              <a:custGeom>
                <a:avLst/>
                <a:gdLst>
                  <a:gd name="textAreaLeft" fmla="*/ 0 w 187200"/>
                  <a:gd name="textAreaRight" fmla="*/ 187560 w 187200"/>
                  <a:gd name="textAreaTop" fmla="*/ 0 h 1700280"/>
                  <a:gd name="textAreaBottom" fmla="*/ 1700640 h 1700280"/>
                </a:gdLst>
                <a:ahLst/>
                <a:rect l="textAreaLeft" t="textAreaTop" r="textAreaRight" b="textAreaBottom"/>
                <a:pathLst>
                  <a:path w="118" h="1071">
                    <a:moveTo>
                      <a:pt x="0" y="0"/>
                    </a:moveTo>
                    <a:lnTo>
                      <a:pt x="0" y="1071"/>
                    </a:lnTo>
                    <a:lnTo>
                      <a:pt x="118" y="1071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41" name="Freeform 104"/>
              <p:cNvSpPr/>
              <p:nvPr/>
            </p:nvSpPr>
            <p:spPr>
              <a:xfrm>
                <a:off x="1322280" y="4687920"/>
                <a:ext cx="122400" cy="1541520"/>
              </a:xfrm>
              <a:custGeom>
                <a:avLst/>
                <a:gdLst>
                  <a:gd name="textAreaLeft" fmla="*/ 0 w 122400"/>
                  <a:gd name="textAreaRight" fmla="*/ 122760 w 122400"/>
                  <a:gd name="textAreaTop" fmla="*/ 0 h 1541520"/>
                  <a:gd name="textAreaBottom" fmla="*/ 1541880 h 1541520"/>
                </a:gdLst>
                <a:ahLst/>
                <a:rect l="textAreaLeft" t="textAreaTop" r="textAreaRight" b="textAreaBottom"/>
                <a:pathLst>
                  <a:path w="77" h="971">
                    <a:moveTo>
                      <a:pt x="0" y="971"/>
                    </a:moveTo>
                    <a:lnTo>
                      <a:pt x="0" y="0"/>
                    </a:lnTo>
                    <a:lnTo>
                      <a:pt x="77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42" name="Rectangle 105"/>
              <p:cNvSpPr/>
              <p:nvPr/>
            </p:nvSpPr>
            <p:spPr>
              <a:xfrm>
                <a:off x="4590360" y="6753240"/>
                <a:ext cx="5220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 </a:t>
                </a: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Zebrafish </a:t>
                </a: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ＭＳ Ｐゴシック"/>
                  </a:rPr>
                  <a:t>ζ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43" name="Freeform 106"/>
              <p:cNvSpPr/>
              <p:nvPr/>
            </p:nvSpPr>
            <p:spPr>
              <a:xfrm>
                <a:off x="2975040" y="6821640"/>
                <a:ext cx="1611360" cy="93600"/>
              </a:xfrm>
              <a:custGeom>
                <a:avLst/>
                <a:gdLst>
                  <a:gd name="textAreaLeft" fmla="*/ 0 w 1611360"/>
                  <a:gd name="textAreaRight" fmla="*/ 1611720 w 1611360"/>
                  <a:gd name="textAreaTop" fmla="*/ 0 h 93600"/>
                  <a:gd name="textAreaBottom" fmla="*/ 93960 h 93600"/>
                </a:gdLst>
                <a:ahLst/>
                <a:rect l="textAreaLeft" t="textAreaTop" r="textAreaRight" b="textAreaBottom"/>
                <a:pathLst>
                  <a:path w="1015" h="59">
                    <a:moveTo>
                      <a:pt x="0" y="59"/>
                    </a:moveTo>
                    <a:lnTo>
                      <a:pt x="0" y="0"/>
                    </a:lnTo>
                    <a:lnTo>
                      <a:pt x="1015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44" name="Rectangle 107"/>
              <p:cNvSpPr/>
              <p:nvPr/>
            </p:nvSpPr>
            <p:spPr>
              <a:xfrm>
                <a:off x="4466880" y="6948720"/>
                <a:ext cx="5770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 </a:t>
                </a: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Grass carp </a:t>
                </a: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ＭＳ Ｐゴシック"/>
                  </a:rPr>
                  <a:t>ζ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45" name="Freeform 108"/>
              <p:cNvSpPr/>
              <p:nvPr/>
            </p:nvSpPr>
            <p:spPr>
              <a:xfrm>
                <a:off x="2975040" y="6923160"/>
                <a:ext cx="1488960" cy="93600"/>
              </a:xfrm>
              <a:custGeom>
                <a:avLst/>
                <a:gdLst>
                  <a:gd name="textAreaLeft" fmla="*/ 0 w 1488960"/>
                  <a:gd name="textAreaRight" fmla="*/ 1489320 w 1488960"/>
                  <a:gd name="textAreaTop" fmla="*/ 0 h 93600"/>
                  <a:gd name="textAreaBottom" fmla="*/ 93960 h 93600"/>
                </a:gdLst>
                <a:ahLst/>
                <a:rect l="textAreaLeft" t="textAreaTop" r="textAreaRight" b="textAreaBottom"/>
                <a:pathLst>
                  <a:path w="938" h="59">
                    <a:moveTo>
                      <a:pt x="0" y="0"/>
                    </a:moveTo>
                    <a:lnTo>
                      <a:pt x="0" y="59"/>
                    </a:lnTo>
                    <a:lnTo>
                      <a:pt x="938" y="59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46" name="Freeform 109"/>
              <p:cNvSpPr/>
              <p:nvPr/>
            </p:nvSpPr>
            <p:spPr>
              <a:xfrm>
                <a:off x="1949400" y="6918480"/>
                <a:ext cx="1025640" cy="252360"/>
              </a:xfrm>
              <a:custGeom>
                <a:avLst/>
                <a:gdLst>
                  <a:gd name="textAreaLeft" fmla="*/ 0 w 1025640"/>
                  <a:gd name="textAreaRight" fmla="*/ 1026000 w 1025640"/>
                  <a:gd name="textAreaTop" fmla="*/ 0 h 252360"/>
                  <a:gd name="textAreaBottom" fmla="*/ 252720 h 252360"/>
                </a:gdLst>
                <a:ahLst/>
                <a:rect l="textAreaLeft" t="textAreaTop" r="textAreaRight" b="textAreaBottom"/>
                <a:pathLst>
                  <a:path w="646" h="159">
                    <a:moveTo>
                      <a:pt x="0" y="159"/>
                    </a:moveTo>
                    <a:lnTo>
                      <a:pt x="0" y="0"/>
                    </a:lnTo>
                    <a:lnTo>
                      <a:pt x="646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47" name="Rectangle 110"/>
              <p:cNvSpPr/>
              <p:nvPr/>
            </p:nvSpPr>
            <p:spPr>
              <a:xfrm>
                <a:off x="4369680" y="7143840"/>
                <a:ext cx="3556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 </a:t>
                </a: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Perch </a:t>
                </a: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ＭＳ Ｐゴシック"/>
                  </a:rPr>
                  <a:t>τ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48" name="Freeform 111"/>
              <p:cNvSpPr/>
              <p:nvPr/>
            </p:nvSpPr>
            <p:spPr>
              <a:xfrm>
                <a:off x="2416320" y="7212240"/>
                <a:ext cx="1950840" cy="215640"/>
              </a:xfrm>
              <a:custGeom>
                <a:avLst/>
                <a:gdLst>
                  <a:gd name="textAreaLeft" fmla="*/ 0 w 1950840"/>
                  <a:gd name="textAreaRight" fmla="*/ 1951200 w 1950840"/>
                  <a:gd name="textAreaTop" fmla="*/ 0 h 215640"/>
                  <a:gd name="textAreaBottom" fmla="*/ 216000 h 215640"/>
                </a:gdLst>
                <a:ahLst/>
                <a:rect l="textAreaLeft" t="textAreaTop" r="textAreaRight" b="textAreaBottom"/>
                <a:pathLst>
                  <a:path w="1229" h="136">
                    <a:moveTo>
                      <a:pt x="0" y="136"/>
                    </a:moveTo>
                    <a:lnTo>
                      <a:pt x="0" y="0"/>
                    </a:lnTo>
                    <a:lnTo>
                      <a:pt x="1229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49" name="Rectangle 112"/>
              <p:cNvSpPr/>
              <p:nvPr/>
            </p:nvSpPr>
            <p:spPr>
              <a:xfrm>
                <a:off x="4273920" y="7338960"/>
                <a:ext cx="916560" cy="138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 </a:t>
                </a: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Atlantic salmon </a:t>
                </a: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ＭＳ Ｐゴシック"/>
                  </a:rPr>
                  <a:t>τ</a:t>
                </a:r>
                <a:r>
                  <a:rPr b="1" lang="en-US" sz="800" spc="-1" strike="noStrike" baseline="-25000">
                    <a:solidFill>
                      <a:srgbClr val="000000"/>
                    </a:solidFill>
                    <a:latin typeface="Times New Roman"/>
                    <a:ea typeface="Arial"/>
                  </a:rPr>
                  <a:t>B</a:t>
                </a: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-2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50" name="Freeform 113"/>
              <p:cNvSpPr/>
              <p:nvPr/>
            </p:nvSpPr>
            <p:spPr>
              <a:xfrm>
                <a:off x="3451320" y="7407360"/>
                <a:ext cx="803160" cy="239760"/>
              </a:xfrm>
              <a:custGeom>
                <a:avLst/>
                <a:gdLst>
                  <a:gd name="textAreaLeft" fmla="*/ 0 w 803160"/>
                  <a:gd name="textAreaRight" fmla="*/ 803520 w 803160"/>
                  <a:gd name="textAreaTop" fmla="*/ 0 h 239760"/>
                  <a:gd name="textAreaBottom" fmla="*/ 240120 h 239760"/>
                </a:gdLst>
                <a:ahLst/>
                <a:rect l="textAreaLeft" t="textAreaTop" r="textAreaRight" b="textAreaBottom"/>
                <a:pathLst>
                  <a:path w="506" h="151">
                    <a:moveTo>
                      <a:pt x="0" y="151"/>
                    </a:moveTo>
                    <a:lnTo>
                      <a:pt x="0" y="0"/>
                    </a:lnTo>
                    <a:lnTo>
                      <a:pt x="506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51" name="Rectangle 114"/>
              <p:cNvSpPr/>
              <p:nvPr/>
            </p:nvSpPr>
            <p:spPr>
              <a:xfrm>
                <a:off x="4204800" y="7534440"/>
                <a:ext cx="919800" cy="138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 </a:t>
                </a: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Atlantic salmon </a:t>
                </a: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ＭＳ Ｐゴシック"/>
                  </a:rPr>
                  <a:t>τ</a:t>
                </a:r>
                <a:r>
                  <a:rPr b="1" lang="en-US" sz="800" spc="-1" strike="noStrike" baseline="-25000">
                    <a:solidFill>
                      <a:srgbClr val="000000"/>
                    </a:solidFill>
                    <a:latin typeface="Times New Roman"/>
                    <a:ea typeface="Arial"/>
                  </a:rPr>
                  <a:t>A</a:t>
                </a: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-4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52" name="Freeform 115"/>
              <p:cNvSpPr/>
              <p:nvPr/>
            </p:nvSpPr>
            <p:spPr>
              <a:xfrm>
                <a:off x="4051440" y="7602480"/>
                <a:ext cx="134640" cy="93960"/>
              </a:xfrm>
              <a:custGeom>
                <a:avLst/>
                <a:gdLst>
                  <a:gd name="textAreaLeft" fmla="*/ 0 w 134640"/>
                  <a:gd name="textAreaRight" fmla="*/ 135000 w 134640"/>
                  <a:gd name="textAreaTop" fmla="*/ 0 h 93960"/>
                  <a:gd name="textAreaBottom" fmla="*/ 94320 h 93960"/>
                </a:gdLst>
                <a:ahLst/>
                <a:rect l="textAreaLeft" t="textAreaTop" r="textAreaRight" b="textAreaBottom"/>
                <a:pathLst>
                  <a:path w="85" h="59">
                    <a:moveTo>
                      <a:pt x="0" y="59"/>
                    </a:moveTo>
                    <a:lnTo>
                      <a:pt x="0" y="0"/>
                    </a:lnTo>
                    <a:lnTo>
                      <a:pt x="85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53" name="Rectangle 116"/>
              <p:cNvSpPr/>
              <p:nvPr/>
            </p:nvSpPr>
            <p:spPr>
              <a:xfrm>
                <a:off x="4281120" y="7729560"/>
                <a:ext cx="919800" cy="138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 </a:t>
                </a: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Atlantic salmon </a:t>
                </a: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ＭＳ Ｐゴシック"/>
                  </a:rPr>
                  <a:t>τ</a:t>
                </a:r>
                <a:r>
                  <a:rPr b="1" lang="en-US" sz="800" spc="-1" strike="noStrike" baseline="-25000">
                    <a:solidFill>
                      <a:srgbClr val="000000"/>
                    </a:solidFill>
                    <a:latin typeface="Times New Roman"/>
                    <a:ea typeface="Arial"/>
                  </a:rPr>
                  <a:t>A</a:t>
                </a: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-5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54" name="Freeform 117"/>
              <p:cNvSpPr/>
              <p:nvPr/>
            </p:nvSpPr>
            <p:spPr>
              <a:xfrm>
                <a:off x="4051440" y="7704360"/>
                <a:ext cx="209520" cy="93600"/>
              </a:xfrm>
              <a:custGeom>
                <a:avLst/>
                <a:gdLst>
                  <a:gd name="textAreaLeft" fmla="*/ 0 w 209520"/>
                  <a:gd name="textAreaRight" fmla="*/ 209880 w 209520"/>
                  <a:gd name="textAreaTop" fmla="*/ 0 h 93600"/>
                  <a:gd name="textAreaBottom" fmla="*/ 93960 h 93600"/>
                </a:gdLst>
                <a:ahLst/>
                <a:rect l="textAreaLeft" t="textAreaTop" r="textAreaRight" b="textAreaBottom"/>
                <a:pathLst>
                  <a:path w="132" h="59">
                    <a:moveTo>
                      <a:pt x="0" y="0"/>
                    </a:moveTo>
                    <a:lnTo>
                      <a:pt x="0" y="59"/>
                    </a:lnTo>
                    <a:lnTo>
                      <a:pt x="132" y="59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55" name="Freeform 118"/>
              <p:cNvSpPr/>
              <p:nvPr/>
            </p:nvSpPr>
            <p:spPr>
              <a:xfrm>
                <a:off x="3652920" y="7699320"/>
                <a:ext cx="398520" cy="192240"/>
              </a:xfrm>
              <a:custGeom>
                <a:avLst/>
                <a:gdLst>
                  <a:gd name="textAreaLeft" fmla="*/ 0 w 398520"/>
                  <a:gd name="textAreaRight" fmla="*/ 398880 w 398520"/>
                  <a:gd name="textAreaTop" fmla="*/ 0 h 192240"/>
                  <a:gd name="textAreaBottom" fmla="*/ 192600 h 192240"/>
                </a:gdLst>
                <a:ahLst/>
                <a:rect l="textAreaLeft" t="textAreaTop" r="textAreaRight" b="textAreaBottom"/>
                <a:pathLst>
                  <a:path w="251" h="121">
                    <a:moveTo>
                      <a:pt x="0" y="121"/>
                    </a:moveTo>
                    <a:lnTo>
                      <a:pt x="0" y="0"/>
                    </a:lnTo>
                    <a:lnTo>
                      <a:pt x="251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56" name="Rectangle 119"/>
              <p:cNvSpPr/>
              <p:nvPr/>
            </p:nvSpPr>
            <p:spPr>
              <a:xfrm>
                <a:off x="4325400" y="7925040"/>
                <a:ext cx="4075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 </a:t>
                </a: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Trout </a:t>
                </a: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ＭＳ Ｐゴシック"/>
                  </a:rPr>
                  <a:t>τ</a:t>
                </a: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1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57" name="Freeform 120"/>
              <p:cNvSpPr/>
              <p:nvPr/>
            </p:nvSpPr>
            <p:spPr>
              <a:xfrm>
                <a:off x="4116240" y="7993080"/>
                <a:ext cx="204840" cy="93600"/>
              </a:xfrm>
              <a:custGeom>
                <a:avLst/>
                <a:gdLst>
                  <a:gd name="textAreaLeft" fmla="*/ 0 w 204840"/>
                  <a:gd name="textAreaRight" fmla="*/ 205200 w 204840"/>
                  <a:gd name="textAreaTop" fmla="*/ 0 h 93600"/>
                  <a:gd name="textAreaBottom" fmla="*/ 93960 h 93600"/>
                </a:gdLst>
                <a:ahLst/>
                <a:rect l="textAreaLeft" t="textAreaTop" r="textAreaRight" b="textAreaBottom"/>
                <a:pathLst>
                  <a:path w="129" h="59">
                    <a:moveTo>
                      <a:pt x="0" y="59"/>
                    </a:moveTo>
                    <a:lnTo>
                      <a:pt x="0" y="0"/>
                    </a:lnTo>
                    <a:lnTo>
                      <a:pt x="129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58" name="Rectangle 121"/>
              <p:cNvSpPr/>
              <p:nvPr/>
            </p:nvSpPr>
            <p:spPr>
              <a:xfrm>
                <a:off x="4258800" y="8120160"/>
                <a:ext cx="4075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 </a:t>
                </a: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Trout </a:t>
                </a: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ＭＳ Ｐゴシック"/>
                  </a:rPr>
                  <a:t>τ</a:t>
                </a: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2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59" name="Freeform 122"/>
              <p:cNvSpPr/>
              <p:nvPr/>
            </p:nvSpPr>
            <p:spPr>
              <a:xfrm>
                <a:off x="4116240" y="8094600"/>
                <a:ext cx="138240" cy="93960"/>
              </a:xfrm>
              <a:custGeom>
                <a:avLst/>
                <a:gdLst>
                  <a:gd name="textAreaLeft" fmla="*/ 0 w 138240"/>
                  <a:gd name="textAreaRight" fmla="*/ 138240 w 138240"/>
                  <a:gd name="textAreaTop" fmla="*/ 0 h 93960"/>
                  <a:gd name="textAreaBottom" fmla="*/ 94320 h 93960"/>
                </a:gdLst>
                <a:ahLst/>
                <a:rect l="textAreaLeft" t="textAreaTop" r="textAreaRight" b="textAreaBottom"/>
                <a:pathLst>
                  <a:path w="87" h="59">
                    <a:moveTo>
                      <a:pt x="0" y="0"/>
                    </a:moveTo>
                    <a:lnTo>
                      <a:pt x="0" y="59"/>
                    </a:lnTo>
                    <a:lnTo>
                      <a:pt x="87" y="59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60" name="Freeform 123"/>
              <p:cNvSpPr/>
              <p:nvPr/>
            </p:nvSpPr>
            <p:spPr>
              <a:xfrm>
                <a:off x="3652920" y="7899480"/>
                <a:ext cx="463320" cy="190440"/>
              </a:xfrm>
              <a:custGeom>
                <a:avLst/>
                <a:gdLst>
                  <a:gd name="textAreaLeft" fmla="*/ 0 w 463320"/>
                  <a:gd name="textAreaRight" fmla="*/ 463680 w 463320"/>
                  <a:gd name="textAreaTop" fmla="*/ 0 h 190440"/>
                  <a:gd name="textAreaBottom" fmla="*/ 190800 h 190440"/>
                </a:gdLst>
                <a:ahLst/>
                <a:rect l="textAreaLeft" t="textAreaTop" r="textAreaRight" b="textAreaBottom"/>
                <a:pathLst>
                  <a:path w="292" h="120">
                    <a:moveTo>
                      <a:pt x="0" y="0"/>
                    </a:moveTo>
                    <a:lnTo>
                      <a:pt x="0" y="120"/>
                    </a:lnTo>
                    <a:lnTo>
                      <a:pt x="292" y="12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61" name="Freeform 124"/>
              <p:cNvSpPr/>
              <p:nvPr/>
            </p:nvSpPr>
            <p:spPr>
              <a:xfrm>
                <a:off x="3451320" y="7655040"/>
                <a:ext cx="201600" cy="239760"/>
              </a:xfrm>
              <a:custGeom>
                <a:avLst/>
                <a:gdLst>
                  <a:gd name="textAreaLeft" fmla="*/ 0 w 201600"/>
                  <a:gd name="textAreaRight" fmla="*/ 201960 w 201600"/>
                  <a:gd name="textAreaTop" fmla="*/ 0 h 239760"/>
                  <a:gd name="textAreaBottom" fmla="*/ 240120 h 239760"/>
                </a:gdLst>
                <a:ahLst/>
                <a:rect l="textAreaLeft" t="textAreaTop" r="textAreaRight" b="textAreaBottom"/>
                <a:pathLst>
                  <a:path w="127" h="151">
                    <a:moveTo>
                      <a:pt x="0" y="0"/>
                    </a:moveTo>
                    <a:lnTo>
                      <a:pt x="0" y="151"/>
                    </a:lnTo>
                    <a:lnTo>
                      <a:pt x="127" y="151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62" name="Freeform 125"/>
              <p:cNvSpPr/>
              <p:nvPr/>
            </p:nvSpPr>
            <p:spPr>
              <a:xfrm>
                <a:off x="2416320" y="7435800"/>
                <a:ext cx="1035000" cy="216000"/>
              </a:xfrm>
              <a:custGeom>
                <a:avLst/>
                <a:gdLst>
                  <a:gd name="textAreaLeft" fmla="*/ 0 w 1035000"/>
                  <a:gd name="textAreaRight" fmla="*/ 1035360 w 1035000"/>
                  <a:gd name="textAreaTop" fmla="*/ 0 h 216000"/>
                  <a:gd name="textAreaBottom" fmla="*/ 216360 h 216000"/>
                </a:gdLst>
                <a:ahLst/>
                <a:rect l="textAreaLeft" t="textAreaTop" r="textAreaRight" b="textAreaBottom"/>
                <a:pathLst>
                  <a:path w="652" h="136">
                    <a:moveTo>
                      <a:pt x="0" y="0"/>
                    </a:moveTo>
                    <a:lnTo>
                      <a:pt x="0" y="136"/>
                    </a:lnTo>
                    <a:lnTo>
                      <a:pt x="652" y="136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63" name="Freeform 126"/>
              <p:cNvSpPr/>
              <p:nvPr/>
            </p:nvSpPr>
            <p:spPr>
              <a:xfrm>
                <a:off x="1949400" y="7178760"/>
                <a:ext cx="466920" cy="252360"/>
              </a:xfrm>
              <a:custGeom>
                <a:avLst/>
                <a:gdLst>
                  <a:gd name="textAreaLeft" fmla="*/ 0 w 466920"/>
                  <a:gd name="textAreaRight" fmla="*/ 467280 w 466920"/>
                  <a:gd name="textAreaTop" fmla="*/ 0 h 252360"/>
                  <a:gd name="textAreaBottom" fmla="*/ 252720 h 252360"/>
                </a:gdLst>
                <a:ahLst/>
                <a:rect l="textAreaLeft" t="textAreaTop" r="textAreaRight" b="textAreaBottom"/>
                <a:pathLst>
                  <a:path w="294" h="159">
                    <a:moveTo>
                      <a:pt x="0" y="0"/>
                    </a:moveTo>
                    <a:lnTo>
                      <a:pt x="0" y="159"/>
                    </a:lnTo>
                    <a:lnTo>
                      <a:pt x="294" y="159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64" name="Freeform 127"/>
              <p:cNvSpPr/>
              <p:nvPr/>
            </p:nvSpPr>
            <p:spPr>
              <a:xfrm>
                <a:off x="1357200" y="7175520"/>
                <a:ext cx="592200" cy="600120"/>
              </a:xfrm>
              <a:custGeom>
                <a:avLst/>
                <a:gdLst>
                  <a:gd name="textAreaLeft" fmla="*/ 0 w 592200"/>
                  <a:gd name="textAreaRight" fmla="*/ 592560 w 592200"/>
                  <a:gd name="textAreaTop" fmla="*/ 0 h 600120"/>
                  <a:gd name="textAreaBottom" fmla="*/ 600480 h 600120"/>
                </a:gdLst>
                <a:ahLst/>
                <a:rect l="textAreaLeft" t="textAreaTop" r="textAreaRight" b="textAreaBottom"/>
                <a:pathLst>
                  <a:path w="373" h="378">
                    <a:moveTo>
                      <a:pt x="0" y="378"/>
                    </a:moveTo>
                    <a:lnTo>
                      <a:pt x="0" y="0"/>
                    </a:lnTo>
                    <a:lnTo>
                      <a:pt x="373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65" name="Rectangle 128"/>
              <p:cNvSpPr/>
              <p:nvPr/>
            </p:nvSpPr>
            <p:spPr>
              <a:xfrm>
                <a:off x="4270680" y="8315280"/>
                <a:ext cx="5187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 </a:t>
                </a: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Lungfish </a:t>
                </a: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ＭＳ Ｐゴシック"/>
                  </a:rPr>
                  <a:t>ω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66" name="Freeform 129"/>
              <p:cNvSpPr/>
              <p:nvPr/>
            </p:nvSpPr>
            <p:spPr>
              <a:xfrm>
                <a:off x="1357200" y="7783560"/>
                <a:ext cx="2908440" cy="600120"/>
              </a:xfrm>
              <a:custGeom>
                <a:avLst/>
                <a:gdLst>
                  <a:gd name="textAreaLeft" fmla="*/ 0 w 2908440"/>
                  <a:gd name="textAreaRight" fmla="*/ 2908800 w 2908440"/>
                  <a:gd name="textAreaTop" fmla="*/ 0 h 600120"/>
                  <a:gd name="textAreaBottom" fmla="*/ 600480 h 600120"/>
                </a:gdLst>
                <a:ahLst/>
                <a:rect l="textAreaLeft" t="textAreaTop" r="textAreaRight" b="textAreaBottom"/>
                <a:pathLst>
                  <a:path w="1832" h="378">
                    <a:moveTo>
                      <a:pt x="0" y="0"/>
                    </a:moveTo>
                    <a:lnTo>
                      <a:pt x="0" y="378"/>
                    </a:lnTo>
                    <a:lnTo>
                      <a:pt x="1832" y="378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67" name="Freeform 130"/>
              <p:cNvSpPr/>
              <p:nvPr/>
            </p:nvSpPr>
            <p:spPr>
              <a:xfrm>
                <a:off x="1322280" y="6237360"/>
                <a:ext cx="34920" cy="1541520"/>
              </a:xfrm>
              <a:custGeom>
                <a:avLst/>
                <a:gdLst>
                  <a:gd name="textAreaLeft" fmla="*/ 0 w 34920"/>
                  <a:gd name="textAreaRight" fmla="*/ 34920 w 34920"/>
                  <a:gd name="textAreaTop" fmla="*/ 0 h 1541520"/>
                  <a:gd name="textAreaBottom" fmla="*/ 1541880 h 1541520"/>
                </a:gdLst>
                <a:ahLst/>
                <a:rect l="textAreaLeft" t="textAreaTop" r="textAreaRight" b="textAreaBottom"/>
                <a:pathLst>
                  <a:path w="22" h="971">
                    <a:moveTo>
                      <a:pt x="0" y="0"/>
                    </a:moveTo>
                    <a:lnTo>
                      <a:pt x="0" y="971"/>
                    </a:lnTo>
                    <a:lnTo>
                      <a:pt x="22" y="971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68" name="Rectangle 131"/>
              <p:cNvSpPr/>
              <p:nvPr/>
            </p:nvSpPr>
            <p:spPr>
              <a:xfrm>
                <a:off x="3972960" y="328680"/>
                <a:ext cx="104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94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69" name="Rectangle 132"/>
              <p:cNvSpPr/>
              <p:nvPr/>
            </p:nvSpPr>
            <p:spPr>
              <a:xfrm>
                <a:off x="3661200" y="476280"/>
                <a:ext cx="156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100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0" name="Rectangle 133"/>
              <p:cNvSpPr/>
              <p:nvPr/>
            </p:nvSpPr>
            <p:spPr>
              <a:xfrm>
                <a:off x="4006080" y="8128080"/>
                <a:ext cx="104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99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1" name="Rectangle 134"/>
              <p:cNvSpPr/>
              <p:nvPr/>
            </p:nvSpPr>
            <p:spPr>
              <a:xfrm>
                <a:off x="3940920" y="7556760"/>
                <a:ext cx="104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99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2" name="Rectangle 135"/>
              <p:cNvSpPr/>
              <p:nvPr/>
            </p:nvSpPr>
            <p:spPr>
              <a:xfrm>
                <a:off x="3542760" y="7932960"/>
                <a:ext cx="104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74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3" name="Rectangle 136"/>
              <p:cNvSpPr/>
              <p:nvPr/>
            </p:nvSpPr>
            <p:spPr>
              <a:xfrm>
                <a:off x="3294360" y="7688520"/>
                <a:ext cx="156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100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4" name="Rectangle 137"/>
              <p:cNvSpPr/>
              <p:nvPr/>
            </p:nvSpPr>
            <p:spPr>
              <a:xfrm>
                <a:off x="2818080" y="6775560"/>
                <a:ext cx="156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100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5" name="Rectangle 138"/>
              <p:cNvSpPr/>
              <p:nvPr/>
            </p:nvSpPr>
            <p:spPr>
              <a:xfrm>
                <a:off x="4097880" y="5602320"/>
                <a:ext cx="156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100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6" name="Rectangle 139"/>
              <p:cNvSpPr/>
              <p:nvPr/>
            </p:nvSpPr>
            <p:spPr>
              <a:xfrm>
                <a:off x="2824920" y="4807080"/>
                <a:ext cx="104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99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7" name="Rectangle 140"/>
              <p:cNvSpPr/>
              <p:nvPr/>
            </p:nvSpPr>
            <p:spPr>
              <a:xfrm>
                <a:off x="3228120" y="5392800"/>
                <a:ext cx="104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99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8" name="Rectangle 141"/>
              <p:cNvSpPr/>
              <p:nvPr/>
            </p:nvSpPr>
            <p:spPr>
              <a:xfrm>
                <a:off x="2502720" y="5246640"/>
                <a:ext cx="104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99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9" name="Rectangle 142"/>
              <p:cNvSpPr/>
              <p:nvPr/>
            </p:nvSpPr>
            <p:spPr>
              <a:xfrm>
                <a:off x="2434680" y="3830760"/>
                <a:ext cx="104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99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0" name="Rectangle 143"/>
              <p:cNvSpPr/>
              <p:nvPr/>
            </p:nvSpPr>
            <p:spPr>
              <a:xfrm>
                <a:off x="2498040" y="4040280"/>
                <a:ext cx="104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99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1" name="Rectangle 144"/>
              <p:cNvSpPr/>
              <p:nvPr/>
            </p:nvSpPr>
            <p:spPr>
              <a:xfrm>
                <a:off x="2304360" y="7469280"/>
                <a:ext cx="104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93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2" name="Rectangle 145"/>
              <p:cNvSpPr/>
              <p:nvPr/>
            </p:nvSpPr>
            <p:spPr>
              <a:xfrm>
                <a:off x="1839240" y="7031160"/>
                <a:ext cx="104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98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3" name="Rectangle 146"/>
              <p:cNvSpPr/>
              <p:nvPr/>
            </p:nvSpPr>
            <p:spPr>
              <a:xfrm>
                <a:off x="2583720" y="2673360"/>
                <a:ext cx="104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94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4" name="Rectangle 147"/>
              <p:cNvSpPr/>
              <p:nvPr/>
            </p:nvSpPr>
            <p:spPr>
              <a:xfrm>
                <a:off x="2415600" y="2073240"/>
                <a:ext cx="104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90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5" name="Rectangle 148"/>
              <p:cNvSpPr/>
              <p:nvPr/>
            </p:nvSpPr>
            <p:spPr>
              <a:xfrm>
                <a:off x="2729880" y="1290600"/>
                <a:ext cx="104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89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6" name="Rectangle 149"/>
              <p:cNvSpPr/>
              <p:nvPr/>
            </p:nvSpPr>
            <p:spPr>
              <a:xfrm>
                <a:off x="1983600" y="4660920"/>
                <a:ext cx="104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85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7" name="Rectangle 150"/>
              <p:cNvSpPr/>
              <p:nvPr/>
            </p:nvSpPr>
            <p:spPr>
              <a:xfrm>
                <a:off x="2380680" y="5749920"/>
                <a:ext cx="104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76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8" name="Rectangle 151"/>
              <p:cNvSpPr/>
              <p:nvPr/>
            </p:nvSpPr>
            <p:spPr>
              <a:xfrm>
                <a:off x="1993320" y="6018120"/>
                <a:ext cx="104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83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9" name="Rectangle 152"/>
              <p:cNvSpPr/>
              <p:nvPr/>
            </p:nvSpPr>
            <p:spPr>
              <a:xfrm>
                <a:off x="2025000" y="1925640"/>
                <a:ext cx="104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82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0" name="Rectangle 153"/>
              <p:cNvSpPr/>
              <p:nvPr/>
            </p:nvSpPr>
            <p:spPr>
              <a:xfrm>
                <a:off x="2313720" y="792360"/>
                <a:ext cx="104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72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1" name="Rectangle 154"/>
              <p:cNvSpPr/>
              <p:nvPr/>
            </p:nvSpPr>
            <p:spPr>
              <a:xfrm>
                <a:off x="2037600" y="1098720"/>
                <a:ext cx="104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72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2" name="Rectangle 155"/>
              <p:cNvSpPr/>
              <p:nvPr/>
            </p:nvSpPr>
            <p:spPr>
              <a:xfrm>
                <a:off x="1751760" y="1422360"/>
                <a:ext cx="104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82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3" name="Rectangle 156"/>
              <p:cNvSpPr/>
              <p:nvPr/>
            </p:nvSpPr>
            <p:spPr>
              <a:xfrm>
                <a:off x="2207520" y="2282760"/>
                <a:ext cx="104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79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4" name="Rectangle 165"/>
              <p:cNvSpPr/>
              <p:nvPr/>
            </p:nvSpPr>
            <p:spPr>
              <a:xfrm>
                <a:off x="1334520" y="4545000"/>
                <a:ext cx="104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50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5" name="Rectangle 166"/>
              <p:cNvSpPr/>
              <p:nvPr/>
            </p:nvSpPr>
            <p:spPr>
              <a:xfrm>
                <a:off x="1521720" y="6431040"/>
                <a:ext cx="104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59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6" name="Line 167"/>
              <p:cNvSpPr/>
              <p:nvPr/>
            </p:nvSpPr>
            <p:spPr>
              <a:xfrm>
                <a:off x="1730520" y="8666280"/>
                <a:ext cx="37116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7" name="Line 168"/>
              <p:cNvSpPr/>
              <p:nvPr/>
            </p:nvSpPr>
            <p:spPr>
              <a:xfrm>
                <a:off x="1730520" y="8634600"/>
                <a:ext cx="1440" cy="6516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8360" bIns="18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8" name="Line 169"/>
              <p:cNvSpPr/>
              <p:nvPr/>
            </p:nvSpPr>
            <p:spPr>
              <a:xfrm>
                <a:off x="2101680" y="8634600"/>
                <a:ext cx="1800" cy="6516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8360" bIns="18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9" name="Rectangle 170"/>
              <p:cNvSpPr/>
              <p:nvPr/>
            </p:nvSpPr>
            <p:spPr>
              <a:xfrm>
                <a:off x="1860840" y="8704440"/>
                <a:ext cx="1821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0.05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200" name="Straight Connector 171"/>
            <p:cNvSpPr/>
            <p:nvPr/>
          </p:nvSpPr>
          <p:spPr>
            <a:xfrm flipH="1">
              <a:off x="5284800" y="353880"/>
              <a:ext cx="1440" cy="27853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1" name="TextBox 173"/>
            <p:cNvSpPr/>
            <p:nvPr/>
          </p:nvSpPr>
          <p:spPr>
            <a:xfrm>
              <a:off x="5274720" y="1566720"/>
              <a:ext cx="369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</a:t>
              </a: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ＭＳ Ｐゴシック"/>
                </a:rPr>
                <a:t>μ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2" name="Straight Connector 183"/>
            <p:cNvSpPr/>
            <p:nvPr/>
          </p:nvSpPr>
          <p:spPr>
            <a:xfrm flipH="1">
              <a:off x="5285520" y="3254760"/>
              <a:ext cx="720" cy="285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3" name="TextBox 190"/>
            <p:cNvSpPr/>
            <p:nvPr/>
          </p:nvSpPr>
          <p:spPr>
            <a:xfrm>
              <a:off x="5286240" y="3209760"/>
              <a:ext cx="369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</a:t>
              </a: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ＭＳ Ｐゴシック"/>
                </a:rPr>
                <a:t>α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4" name="Straight Connector 191"/>
            <p:cNvSpPr/>
            <p:nvPr/>
          </p:nvSpPr>
          <p:spPr>
            <a:xfrm flipH="1">
              <a:off x="5286240" y="5638680"/>
              <a:ext cx="1440" cy="1000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5" name="Straight Connector 192"/>
            <p:cNvSpPr/>
            <p:nvPr/>
          </p:nvSpPr>
          <p:spPr>
            <a:xfrm flipH="1">
              <a:off x="5286240" y="3638520"/>
              <a:ext cx="720" cy="285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6" name="Straight Connector 193"/>
            <p:cNvSpPr/>
            <p:nvPr/>
          </p:nvSpPr>
          <p:spPr>
            <a:xfrm flipH="1">
              <a:off x="5285520" y="4046760"/>
              <a:ext cx="720" cy="285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7" name="Straight Connector 194"/>
            <p:cNvSpPr/>
            <p:nvPr/>
          </p:nvSpPr>
          <p:spPr>
            <a:xfrm flipH="1">
              <a:off x="5285520" y="4604760"/>
              <a:ext cx="720" cy="285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8" name="Straight Connector 195"/>
            <p:cNvSpPr/>
            <p:nvPr/>
          </p:nvSpPr>
          <p:spPr>
            <a:xfrm flipH="1">
              <a:off x="5285520" y="4995720"/>
              <a:ext cx="720" cy="500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9" name="Straight Connector 199"/>
            <p:cNvSpPr/>
            <p:nvPr/>
          </p:nvSpPr>
          <p:spPr>
            <a:xfrm flipH="1">
              <a:off x="5286240" y="6781680"/>
              <a:ext cx="1440" cy="1428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0" name="TextBox 202"/>
            <p:cNvSpPr/>
            <p:nvPr/>
          </p:nvSpPr>
          <p:spPr>
            <a:xfrm>
              <a:off x="5286240" y="3995640"/>
              <a:ext cx="369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</a:t>
              </a: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ＭＳ Ｐゴシック"/>
                </a:rPr>
                <a:t>ε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1" name="TextBox 203"/>
            <p:cNvSpPr/>
            <p:nvPr/>
          </p:nvSpPr>
          <p:spPr>
            <a:xfrm>
              <a:off x="5286240" y="4567320"/>
              <a:ext cx="369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</a:t>
              </a: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ＭＳ Ｐゴシック"/>
                </a:rPr>
                <a:t>γ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2" name="TextBox 204"/>
            <p:cNvSpPr/>
            <p:nvPr/>
          </p:nvSpPr>
          <p:spPr>
            <a:xfrm>
              <a:off x="5286240" y="6004800"/>
              <a:ext cx="369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</a:t>
              </a: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ＭＳ Ｐゴシック"/>
                </a:rPr>
                <a:t>δ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3" name="TextBox 205"/>
            <p:cNvSpPr/>
            <p:nvPr/>
          </p:nvSpPr>
          <p:spPr>
            <a:xfrm>
              <a:off x="5286240" y="7282080"/>
              <a:ext cx="7858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</a:t>
              </a: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ＭＳ Ｐゴシック"/>
                </a:rPr>
                <a:t>ζ/τ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4" name="TextBox 206"/>
            <p:cNvSpPr/>
            <p:nvPr/>
          </p:nvSpPr>
          <p:spPr>
            <a:xfrm>
              <a:off x="5286240" y="3566880"/>
              <a:ext cx="142884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Shark and skate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</a:t>
              </a: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ＭＳ Ｐゴシック"/>
                </a:rPr>
                <a:t>μ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5" name="Rectangle 207"/>
            <p:cNvSpPr/>
            <p:nvPr/>
          </p:nvSpPr>
          <p:spPr>
            <a:xfrm>
              <a:off x="5286240" y="4995720"/>
              <a:ext cx="135720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Shark and skate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</a:t>
              </a: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ＭＳ Ｐゴシック"/>
                </a:rPr>
                <a:t>ω and NAR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1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10-20T23:22:08Z</dcterms:created>
  <dc:creator>Motoshige</dc:creator>
  <dc:description/>
  <dc:language>en-US</dc:language>
  <cp:lastModifiedBy>Motoshige</cp:lastModifiedBy>
  <dcterms:modified xsi:type="dcterms:W3CDTF">2010-02-13T00:18:37Z</dcterms:modified>
  <cp:revision>4</cp:revision>
  <dc:subject/>
  <dc:title>Slide 1</dc:title>
</cp:coreProperties>
</file>